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7199313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22" userDrawn="1">
          <p15:clr>
            <a:srgbClr val="A4A3A4"/>
          </p15:clr>
        </p15:guide>
        <p15:guide id="2" pos="226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ABBADF9-FE45-454D-B6CE-1671F56E4272}" v="30" dt="2021-08-28T02:45:02.36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50" autoAdjust="0"/>
    <p:restoredTop sz="94660"/>
  </p:normalViewPr>
  <p:slideViewPr>
    <p:cSldViewPr snapToGrid="0">
      <p:cViewPr varScale="1">
        <p:scale>
          <a:sx n="147" d="100"/>
          <a:sy n="147" d="100"/>
        </p:scale>
        <p:origin x="228" y="126"/>
      </p:cViewPr>
      <p:guideLst>
        <p:guide orient="horz" pos="2722"/>
        <p:guide pos="226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tanabe Satoshi" userId="ca2b3ca5d2e030cf" providerId="LiveId" clId="{A14B54B9-AFBC-4684-84A1-42EBBED987C4}"/>
    <pc:docChg chg="undo custSel modSld">
      <pc:chgData name="Watanabe Satoshi" userId="ca2b3ca5d2e030cf" providerId="LiveId" clId="{A14B54B9-AFBC-4684-84A1-42EBBED987C4}" dt="2021-08-28T06:46:27.392" v="21" actId="12789"/>
      <pc:docMkLst>
        <pc:docMk/>
      </pc:docMkLst>
      <pc:sldChg chg="modSp mod">
        <pc:chgData name="Watanabe Satoshi" userId="ca2b3ca5d2e030cf" providerId="LiveId" clId="{A14B54B9-AFBC-4684-84A1-42EBBED987C4}" dt="2021-08-28T06:46:27.392" v="21" actId="12789"/>
        <pc:sldMkLst>
          <pc:docMk/>
          <pc:sldMk cId="2948486128" sldId="256"/>
        </pc:sldMkLst>
        <pc:spChg chg="mod">
          <ac:chgData name="Watanabe Satoshi" userId="ca2b3ca5d2e030cf" providerId="LiveId" clId="{A14B54B9-AFBC-4684-84A1-42EBBED987C4}" dt="2021-08-28T06:46:27.392" v="21" actId="12789"/>
          <ac:spMkLst>
            <pc:docMk/>
            <pc:sldMk cId="2948486128" sldId="256"/>
            <ac:spMk id="32" creationId="{00991F26-2F59-43B3-8EE5-E257BDA222B2}"/>
          </ac:spMkLst>
        </pc:spChg>
        <pc:spChg chg="mod">
          <ac:chgData name="Watanabe Satoshi" userId="ca2b3ca5d2e030cf" providerId="LiveId" clId="{A14B54B9-AFBC-4684-84A1-42EBBED987C4}" dt="2021-08-28T06:46:27.392" v="21" actId="12789"/>
          <ac:spMkLst>
            <pc:docMk/>
            <pc:sldMk cId="2948486128" sldId="256"/>
            <ac:spMk id="33" creationId="{0FBE97C3-46EE-4DE3-AE33-61FF125F5CAA}"/>
          </ac:spMkLst>
        </pc:spChg>
        <pc:spChg chg="mod">
          <ac:chgData name="Watanabe Satoshi" userId="ca2b3ca5d2e030cf" providerId="LiveId" clId="{A14B54B9-AFBC-4684-84A1-42EBBED987C4}" dt="2021-08-28T06:46:27.392" v="21" actId="12789"/>
          <ac:spMkLst>
            <pc:docMk/>
            <pc:sldMk cId="2948486128" sldId="256"/>
            <ac:spMk id="34" creationId="{E3687B74-3E33-4097-BE09-E5E5B5B0A9C0}"/>
          </ac:spMkLst>
        </pc:spChg>
        <pc:spChg chg="mod">
          <ac:chgData name="Watanabe Satoshi" userId="ca2b3ca5d2e030cf" providerId="LiveId" clId="{A14B54B9-AFBC-4684-84A1-42EBBED987C4}" dt="2021-08-28T06:46:27.392" v="21" actId="12789"/>
          <ac:spMkLst>
            <pc:docMk/>
            <pc:sldMk cId="2948486128" sldId="256"/>
            <ac:spMk id="35" creationId="{5E1FA7B8-6962-4F7D-8767-C716DFB3878E}"/>
          </ac:spMkLst>
        </pc:spChg>
        <pc:spChg chg="mod">
          <ac:chgData name="Watanabe Satoshi" userId="ca2b3ca5d2e030cf" providerId="LiveId" clId="{A14B54B9-AFBC-4684-84A1-42EBBED987C4}" dt="2021-08-28T06:46:27.392" v="21" actId="12789"/>
          <ac:spMkLst>
            <pc:docMk/>
            <pc:sldMk cId="2948486128" sldId="256"/>
            <ac:spMk id="36" creationId="{9F9E805E-0E09-4E2E-9093-C10A8F61EC65}"/>
          </ac:spMkLst>
        </pc:spChg>
        <pc:spChg chg="mod">
          <ac:chgData name="Watanabe Satoshi" userId="ca2b3ca5d2e030cf" providerId="LiveId" clId="{A14B54B9-AFBC-4684-84A1-42EBBED987C4}" dt="2021-08-28T06:46:27.392" v="21" actId="12789"/>
          <ac:spMkLst>
            <pc:docMk/>
            <pc:sldMk cId="2948486128" sldId="256"/>
            <ac:spMk id="37" creationId="{091BB1DA-1D99-40AA-B42C-06F8F8574B13}"/>
          </ac:spMkLst>
        </pc:spChg>
        <pc:spChg chg="mod">
          <ac:chgData name="Watanabe Satoshi" userId="ca2b3ca5d2e030cf" providerId="LiveId" clId="{A14B54B9-AFBC-4684-84A1-42EBBED987C4}" dt="2021-08-28T06:46:27.392" v="21" actId="12789"/>
          <ac:spMkLst>
            <pc:docMk/>
            <pc:sldMk cId="2948486128" sldId="256"/>
            <ac:spMk id="38" creationId="{F568EF79-ED3A-4AC8-9218-E565FDCCD51D}"/>
          </ac:spMkLst>
        </pc:spChg>
        <pc:spChg chg="mod">
          <ac:chgData name="Watanabe Satoshi" userId="ca2b3ca5d2e030cf" providerId="LiveId" clId="{A14B54B9-AFBC-4684-84A1-42EBBED987C4}" dt="2021-08-28T06:46:27.392" v="21" actId="12789"/>
          <ac:spMkLst>
            <pc:docMk/>
            <pc:sldMk cId="2948486128" sldId="256"/>
            <ac:spMk id="39" creationId="{BC2EFD59-F1E9-431B-B9B2-3DB39DAF9EE8}"/>
          </ac:spMkLst>
        </pc:spChg>
        <pc:spChg chg="mod">
          <ac:chgData name="Watanabe Satoshi" userId="ca2b3ca5d2e030cf" providerId="LiveId" clId="{A14B54B9-AFBC-4684-84A1-42EBBED987C4}" dt="2021-08-28T06:46:27.392" v="21" actId="12789"/>
          <ac:spMkLst>
            <pc:docMk/>
            <pc:sldMk cId="2948486128" sldId="256"/>
            <ac:spMk id="40" creationId="{FC96A51E-12E9-410C-9076-D51DB7FB1E44}"/>
          </ac:spMkLst>
        </pc:spChg>
        <pc:spChg chg="mod">
          <ac:chgData name="Watanabe Satoshi" userId="ca2b3ca5d2e030cf" providerId="LiveId" clId="{A14B54B9-AFBC-4684-84A1-42EBBED987C4}" dt="2021-08-28T06:45:41.997" v="19" actId="12789"/>
          <ac:spMkLst>
            <pc:docMk/>
            <pc:sldMk cId="2948486128" sldId="256"/>
            <ac:spMk id="66" creationId="{11516493-97E9-4BAF-8E84-76ECF8050606}"/>
          </ac:spMkLst>
        </pc:spChg>
        <pc:spChg chg="mod">
          <ac:chgData name="Watanabe Satoshi" userId="ca2b3ca5d2e030cf" providerId="LiveId" clId="{A14B54B9-AFBC-4684-84A1-42EBBED987C4}" dt="2021-08-28T06:44:02.285" v="13" actId="1076"/>
          <ac:spMkLst>
            <pc:docMk/>
            <pc:sldMk cId="2948486128" sldId="256"/>
            <ac:spMk id="68" creationId="{E52B28A1-A923-445E-B5D4-3C3E0A2F4D1E}"/>
          </ac:spMkLst>
        </pc:spChg>
        <pc:spChg chg="mod">
          <ac:chgData name="Watanabe Satoshi" userId="ca2b3ca5d2e030cf" providerId="LiveId" clId="{A14B54B9-AFBC-4684-84A1-42EBBED987C4}" dt="2021-08-28T06:45:41.997" v="19" actId="12789"/>
          <ac:spMkLst>
            <pc:docMk/>
            <pc:sldMk cId="2948486128" sldId="256"/>
            <ac:spMk id="150" creationId="{B2DCE32E-1D1D-4EA9-9FA3-9EF93AAE70B6}"/>
          </ac:spMkLst>
        </pc:spChg>
        <pc:spChg chg="mod">
          <ac:chgData name="Watanabe Satoshi" userId="ca2b3ca5d2e030cf" providerId="LiveId" clId="{A14B54B9-AFBC-4684-84A1-42EBBED987C4}" dt="2021-08-28T06:43:41.202" v="11" actId="12789"/>
          <ac:spMkLst>
            <pc:docMk/>
            <pc:sldMk cId="2948486128" sldId="256"/>
            <ac:spMk id="152" creationId="{F8CC6286-56E6-460B-81E9-4341F6EFD847}"/>
          </ac:spMkLst>
        </pc:spChg>
        <pc:spChg chg="mod">
          <ac:chgData name="Watanabe Satoshi" userId="ca2b3ca5d2e030cf" providerId="LiveId" clId="{A14B54B9-AFBC-4684-84A1-42EBBED987C4}" dt="2021-08-28T06:45:41.997" v="19" actId="12789"/>
          <ac:spMkLst>
            <pc:docMk/>
            <pc:sldMk cId="2948486128" sldId="256"/>
            <ac:spMk id="154" creationId="{DFC29438-7775-44AD-9FFC-E6EED2AEFE78}"/>
          </ac:spMkLst>
        </pc:spChg>
        <pc:spChg chg="mod">
          <ac:chgData name="Watanabe Satoshi" userId="ca2b3ca5d2e030cf" providerId="LiveId" clId="{A14B54B9-AFBC-4684-84A1-42EBBED987C4}" dt="2021-08-28T06:43:41.202" v="11" actId="12789"/>
          <ac:spMkLst>
            <pc:docMk/>
            <pc:sldMk cId="2948486128" sldId="256"/>
            <ac:spMk id="156" creationId="{4121DD79-7C0E-4179-BCD5-9B2D10D11453}"/>
          </ac:spMkLst>
        </pc:spChg>
        <pc:spChg chg="mod">
          <ac:chgData name="Watanabe Satoshi" userId="ca2b3ca5d2e030cf" providerId="LiveId" clId="{A14B54B9-AFBC-4684-84A1-42EBBED987C4}" dt="2021-08-28T06:45:41.997" v="19" actId="12789"/>
          <ac:spMkLst>
            <pc:docMk/>
            <pc:sldMk cId="2948486128" sldId="256"/>
            <ac:spMk id="158" creationId="{2BABB285-24E7-4BA3-A2C5-BCF2172F0527}"/>
          </ac:spMkLst>
        </pc:spChg>
        <pc:spChg chg="mod">
          <ac:chgData name="Watanabe Satoshi" userId="ca2b3ca5d2e030cf" providerId="LiveId" clId="{A14B54B9-AFBC-4684-84A1-42EBBED987C4}" dt="2021-08-28T06:43:41.202" v="11" actId="12789"/>
          <ac:spMkLst>
            <pc:docMk/>
            <pc:sldMk cId="2948486128" sldId="256"/>
            <ac:spMk id="160" creationId="{55869DFA-B67F-402C-B5FC-940BC4322366}"/>
          </ac:spMkLst>
        </pc:spChg>
        <pc:spChg chg="mod">
          <ac:chgData name="Watanabe Satoshi" userId="ca2b3ca5d2e030cf" providerId="LiveId" clId="{A14B54B9-AFBC-4684-84A1-42EBBED987C4}" dt="2021-08-28T06:45:41.997" v="19" actId="12789"/>
          <ac:spMkLst>
            <pc:docMk/>
            <pc:sldMk cId="2948486128" sldId="256"/>
            <ac:spMk id="162" creationId="{F45D1759-436C-4D6E-9147-B964DF8E7D67}"/>
          </ac:spMkLst>
        </pc:spChg>
        <pc:spChg chg="mod">
          <ac:chgData name="Watanabe Satoshi" userId="ca2b3ca5d2e030cf" providerId="LiveId" clId="{A14B54B9-AFBC-4684-84A1-42EBBED987C4}" dt="2021-08-28T06:43:41.202" v="11" actId="12789"/>
          <ac:spMkLst>
            <pc:docMk/>
            <pc:sldMk cId="2948486128" sldId="256"/>
            <ac:spMk id="164" creationId="{6C7E508B-140B-48AF-BB15-10B8DC43DD37}"/>
          </ac:spMkLst>
        </pc:spChg>
        <pc:spChg chg="mod">
          <ac:chgData name="Watanabe Satoshi" userId="ca2b3ca5d2e030cf" providerId="LiveId" clId="{A14B54B9-AFBC-4684-84A1-42EBBED987C4}" dt="2021-08-28T06:45:41.997" v="19" actId="12789"/>
          <ac:spMkLst>
            <pc:docMk/>
            <pc:sldMk cId="2948486128" sldId="256"/>
            <ac:spMk id="166" creationId="{29861061-9AE4-4C74-A73A-4EE942B3D37F}"/>
          </ac:spMkLst>
        </pc:spChg>
        <pc:spChg chg="mod">
          <ac:chgData name="Watanabe Satoshi" userId="ca2b3ca5d2e030cf" providerId="LiveId" clId="{A14B54B9-AFBC-4684-84A1-42EBBED987C4}" dt="2021-08-28T06:43:41.202" v="11" actId="12789"/>
          <ac:spMkLst>
            <pc:docMk/>
            <pc:sldMk cId="2948486128" sldId="256"/>
            <ac:spMk id="168" creationId="{1A84CC83-5DA6-48F3-A2A7-39E8FCF87229}"/>
          </ac:spMkLst>
        </pc:spChg>
        <pc:spChg chg="mod">
          <ac:chgData name="Watanabe Satoshi" userId="ca2b3ca5d2e030cf" providerId="LiveId" clId="{A14B54B9-AFBC-4684-84A1-42EBBED987C4}" dt="2021-08-28T06:45:41.997" v="19" actId="12789"/>
          <ac:spMkLst>
            <pc:docMk/>
            <pc:sldMk cId="2948486128" sldId="256"/>
            <ac:spMk id="170" creationId="{AB2797B4-88DC-4537-B9C0-531B263D5059}"/>
          </ac:spMkLst>
        </pc:spChg>
        <pc:spChg chg="mod">
          <ac:chgData name="Watanabe Satoshi" userId="ca2b3ca5d2e030cf" providerId="LiveId" clId="{A14B54B9-AFBC-4684-84A1-42EBBED987C4}" dt="2021-08-28T06:43:41.202" v="11" actId="12789"/>
          <ac:spMkLst>
            <pc:docMk/>
            <pc:sldMk cId="2948486128" sldId="256"/>
            <ac:spMk id="172" creationId="{BAF923C9-5D37-459E-BA0C-194A60964211}"/>
          </ac:spMkLst>
        </pc:spChg>
        <pc:spChg chg="mod">
          <ac:chgData name="Watanabe Satoshi" userId="ca2b3ca5d2e030cf" providerId="LiveId" clId="{A14B54B9-AFBC-4684-84A1-42EBBED987C4}" dt="2021-08-28T06:45:41.997" v="19" actId="12789"/>
          <ac:spMkLst>
            <pc:docMk/>
            <pc:sldMk cId="2948486128" sldId="256"/>
            <ac:spMk id="174" creationId="{71953143-7837-42EC-B07D-DA5539E99B53}"/>
          </ac:spMkLst>
        </pc:spChg>
        <pc:spChg chg="mod">
          <ac:chgData name="Watanabe Satoshi" userId="ca2b3ca5d2e030cf" providerId="LiveId" clId="{A14B54B9-AFBC-4684-84A1-42EBBED987C4}" dt="2021-08-28T06:43:41.202" v="11" actId="12789"/>
          <ac:spMkLst>
            <pc:docMk/>
            <pc:sldMk cId="2948486128" sldId="256"/>
            <ac:spMk id="176" creationId="{C30B962C-E610-4097-AC4D-9E7709B77464}"/>
          </ac:spMkLst>
        </pc:spChg>
        <pc:spChg chg="mod">
          <ac:chgData name="Watanabe Satoshi" userId="ca2b3ca5d2e030cf" providerId="LiveId" clId="{A14B54B9-AFBC-4684-84A1-42EBBED987C4}" dt="2021-08-28T06:42:17.102" v="2" actId="1076"/>
          <ac:spMkLst>
            <pc:docMk/>
            <pc:sldMk cId="2948486128" sldId="256"/>
            <ac:spMk id="178" creationId="{628B0AD0-9982-44A6-B031-7EC27A00C6AD}"/>
          </ac:spMkLst>
        </pc:spChg>
        <pc:spChg chg="mod">
          <ac:chgData name="Watanabe Satoshi" userId="ca2b3ca5d2e030cf" providerId="LiveId" clId="{A14B54B9-AFBC-4684-84A1-42EBBED987C4}" dt="2021-08-28T06:43:41.202" v="11" actId="12789"/>
          <ac:spMkLst>
            <pc:docMk/>
            <pc:sldMk cId="2948486128" sldId="256"/>
            <ac:spMk id="180" creationId="{0069E8C7-C6A2-47BB-863E-B5290B541664}"/>
          </ac:spMkLst>
        </pc:spChg>
        <pc:spChg chg="mod">
          <ac:chgData name="Watanabe Satoshi" userId="ca2b3ca5d2e030cf" providerId="LiveId" clId="{A14B54B9-AFBC-4684-84A1-42EBBED987C4}" dt="2021-08-28T06:45:41.997" v="19" actId="12789"/>
          <ac:spMkLst>
            <pc:docMk/>
            <pc:sldMk cId="2948486128" sldId="256"/>
            <ac:spMk id="182" creationId="{B84FE761-7571-4753-8D0B-B709D7F03772}"/>
          </ac:spMkLst>
        </pc:spChg>
        <pc:graphicFrameChg chg="mod">
          <ac:chgData name="Watanabe Satoshi" userId="ca2b3ca5d2e030cf" providerId="LiveId" clId="{A14B54B9-AFBC-4684-84A1-42EBBED987C4}" dt="2021-08-28T06:41:52.721" v="1" actId="404"/>
          <ac:graphicFrameMkLst>
            <pc:docMk/>
            <pc:sldMk cId="2948486128" sldId="256"/>
            <ac:graphicFrameMk id="42" creationId="{8EA0B5EA-23CA-4FAC-ADF7-62BC17A7575D}"/>
          </ac:graphicFrameMkLst>
        </pc:graphicFrameChg>
      </pc:sldChg>
    </pc:docChg>
  </pc:docChgLst>
  <pc:docChgLst>
    <pc:chgData name="藤崎 俊哉" userId="3a509560378e58bd" providerId="LiveId" clId="{2ABBADF9-FE45-454D-B6CE-1671F56E4272}"/>
    <pc:docChg chg="undo redo custSel modSld modMainMaster">
      <pc:chgData name="藤崎 俊哉" userId="3a509560378e58bd" providerId="LiveId" clId="{2ABBADF9-FE45-454D-B6CE-1671F56E4272}" dt="2021-08-28T02:46:39.331" v="771" actId="255"/>
      <pc:docMkLst>
        <pc:docMk/>
      </pc:docMkLst>
      <pc:sldChg chg="addSp delSp modSp mod">
        <pc:chgData name="藤崎 俊哉" userId="3a509560378e58bd" providerId="LiveId" clId="{2ABBADF9-FE45-454D-B6CE-1671F56E4272}" dt="2021-08-28T02:46:39.331" v="771" actId="255"/>
        <pc:sldMkLst>
          <pc:docMk/>
          <pc:sldMk cId="2948486128" sldId="256"/>
        </pc:sldMkLst>
        <pc:spChg chg="mod">
          <ac:chgData name="藤崎 俊哉" userId="3a509560378e58bd" providerId="LiveId" clId="{2ABBADF9-FE45-454D-B6CE-1671F56E4272}" dt="2021-08-28T02:46:10.001" v="767" actId="255"/>
          <ac:spMkLst>
            <pc:docMk/>
            <pc:sldMk cId="2948486128" sldId="256"/>
            <ac:spMk id="31" creationId="{A3AF4D88-E400-4C19-B94D-82E140AF90C4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32" creationId="{00991F26-2F59-43B3-8EE5-E257BDA222B2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33" creationId="{0FBE97C3-46EE-4DE3-AE33-61FF125F5CAA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34" creationId="{E3687B74-3E33-4097-BE09-E5E5B5B0A9C0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35" creationId="{5E1FA7B8-6962-4F7D-8767-C716DFB3878E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36" creationId="{9F9E805E-0E09-4E2E-9093-C10A8F61EC65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37" creationId="{091BB1DA-1D99-40AA-B42C-06F8F8574B13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38" creationId="{F568EF79-ED3A-4AC8-9218-E565FDCCD51D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39" creationId="{BC2EFD59-F1E9-431B-B9B2-3DB39DAF9EE8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40" creationId="{FC96A51E-12E9-410C-9076-D51DB7FB1E44}"/>
          </ac:spMkLst>
        </pc:spChg>
        <pc:spChg chg="mod">
          <ac:chgData name="藤崎 俊哉" userId="3a509560378e58bd" providerId="LiveId" clId="{2ABBADF9-FE45-454D-B6CE-1671F56E4272}" dt="2021-08-28T02:45:37.899" v="766" actId="14100"/>
          <ac:spMkLst>
            <pc:docMk/>
            <pc:sldMk cId="2948486128" sldId="256"/>
            <ac:spMk id="41" creationId="{CA030166-5B51-4B78-8F78-A23BC4330BA7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66" creationId="{11516493-97E9-4BAF-8E84-76ECF8050606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68" creationId="{E52B28A1-A923-445E-B5D4-3C3E0A2F4D1E}"/>
          </ac:spMkLst>
        </pc:spChg>
        <pc:spChg chg="mod">
          <ac:chgData name="藤崎 俊哉" userId="3a509560378e58bd" providerId="LiveId" clId="{2ABBADF9-FE45-454D-B6CE-1671F56E4272}" dt="2021-08-28T02:46:10.001" v="767" actId="255"/>
          <ac:spMkLst>
            <pc:docMk/>
            <pc:sldMk cId="2948486128" sldId="256"/>
            <ac:spMk id="70" creationId="{8279C8C8-BE71-4977-8A7A-DE520183F41A}"/>
          </ac:spMkLst>
        </pc:spChg>
        <pc:spChg chg="mod">
          <ac:chgData name="藤崎 俊哉" userId="3a509560378e58bd" providerId="LiveId" clId="{2ABBADF9-FE45-454D-B6CE-1671F56E4272}" dt="2021-08-28T02:46:10.001" v="767" actId="255"/>
          <ac:spMkLst>
            <pc:docMk/>
            <pc:sldMk cId="2948486128" sldId="256"/>
            <ac:spMk id="72" creationId="{29AC60A8-5230-4D83-9525-2993AA7369C8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44" creationId="{D211C5E8-B412-44A9-A4F0-F33242D1599E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50" creationId="{B2DCE32E-1D1D-4EA9-9FA3-9EF93AAE70B6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52" creationId="{F8CC6286-56E6-460B-81E9-4341F6EFD847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54" creationId="{DFC29438-7775-44AD-9FFC-E6EED2AEFE78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56" creationId="{4121DD79-7C0E-4179-BCD5-9B2D10D11453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58" creationId="{2BABB285-24E7-4BA3-A2C5-BCF2172F0527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60" creationId="{55869DFA-B67F-402C-B5FC-940BC4322366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62" creationId="{F45D1759-436C-4D6E-9147-B964DF8E7D67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64" creationId="{6C7E508B-140B-48AF-BB15-10B8DC43DD37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66" creationId="{29861061-9AE4-4C74-A73A-4EE942B3D37F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68" creationId="{1A84CC83-5DA6-48F3-A2A7-39E8FCF87229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70" creationId="{AB2797B4-88DC-4537-B9C0-531B263D5059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72" creationId="{BAF923C9-5D37-459E-BA0C-194A60964211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74" creationId="{71953143-7837-42EC-B07D-DA5539E99B53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76" creationId="{C30B962C-E610-4097-AC4D-9E7709B77464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78" creationId="{628B0AD0-9982-44A6-B031-7EC27A00C6AD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80" creationId="{0069E8C7-C6A2-47BB-863E-B5290B541664}"/>
          </ac:spMkLst>
        </pc:spChg>
        <pc:spChg chg="mod">
          <ac:chgData name="藤崎 俊哉" userId="3a509560378e58bd" providerId="LiveId" clId="{2ABBADF9-FE45-454D-B6CE-1671F56E4272}" dt="2021-08-28T02:46:39.331" v="771" actId="255"/>
          <ac:spMkLst>
            <pc:docMk/>
            <pc:sldMk cId="2948486128" sldId="256"/>
            <ac:spMk id="182" creationId="{B84FE761-7571-4753-8D0B-B709D7F03772}"/>
          </ac:spMkLst>
        </pc:spChg>
        <pc:spChg chg="mod">
          <ac:chgData name="藤崎 俊哉" userId="3a509560378e58bd" providerId="LiveId" clId="{2ABBADF9-FE45-454D-B6CE-1671F56E4272}" dt="2021-08-28T02:46:23.348" v="770" actId="1076"/>
          <ac:spMkLst>
            <pc:docMk/>
            <pc:sldMk cId="2948486128" sldId="256"/>
            <ac:spMk id="197" creationId="{98056808-983E-45C2-BC73-CAA14417FC88}"/>
          </ac:spMkLst>
        </pc:spChg>
        <pc:spChg chg="mod">
          <ac:chgData name="藤崎 俊哉" userId="3a509560378e58bd" providerId="LiveId" clId="{2ABBADF9-FE45-454D-B6CE-1671F56E4272}" dt="2021-08-28T02:45:18.500" v="763" actId="1036"/>
          <ac:spMkLst>
            <pc:docMk/>
            <pc:sldMk cId="2948486128" sldId="256"/>
            <ac:spMk id="199" creationId="{8229E77F-B649-4A79-876D-767F590BCD9C}"/>
          </ac:spMkLst>
        </pc:spChg>
        <pc:graphicFrameChg chg="del">
          <ac:chgData name="藤崎 俊哉" userId="3a509560378e58bd" providerId="LiveId" clId="{2ABBADF9-FE45-454D-B6CE-1671F56E4272}" dt="2021-08-28T02:18:05.532" v="161" actId="478"/>
          <ac:graphicFrameMkLst>
            <pc:docMk/>
            <pc:sldMk cId="2948486128" sldId="256"/>
            <ac:graphicFrameMk id="29" creationId="{F6F6FC04-CE0F-4C77-B841-C7BBAC6477B3}"/>
          </ac:graphicFrameMkLst>
        </pc:graphicFrameChg>
        <pc:graphicFrameChg chg="add mod ord">
          <ac:chgData name="藤崎 俊哉" userId="3a509560378e58bd" providerId="LiveId" clId="{2ABBADF9-FE45-454D-B6CE-1671F56E4272}" dt="2021-08-28T02:45:18.500" v="763" actId="1036"/>
          <ac:graphicFrameMkLst>
            <pc:docMk/>
            <pc:sldMk cId="2948486128" sldId="256"/>
            <ac:graphicFrameMk id="42" creationId="{8EA0B5EA-23CA-4FAC-ADF7-62BC17A7575D}"/>
          </ac:graphicFrameMkLst>
        </pc:graphicFrameChg>
        <pc:cxnChg chg="mod">
          <ac:chgData name="藤崎 俊哉" userId="3a509560378e58bd" providerId="LiveId" clId="{2ABBADF9-FE45-454D-B6CE-1671F56E4272}" dt="2021-08-28T02:45:18.500" v="763" actId="1036"/>
          <ac:cxnSpMkLst>
            <pc:docMk/>
            <pc:sldMk cId="2948486128" sldId="256"/>
            <ac:cxnSpMk id="30" creationId="{06897BA1-F74F-439C-A31D-EDD30C1DFED4}"/>
          </ac:cxnSpMkLst>
        </pc:cxnChg>
        <pc:cxnChg chg="mod">
          <ac:chgData name="藤崎 俊哉" userId="3a509560378e58bd" providerId="LiveId" clId="{2ABBADF9-FE45-454D-B6CE-1671F56E4272}" dt="2021-08-28T02:45:18.500" v="763" actId="1036"/>
          <ac:cxnSpMkLst>
            <pc:docMk/>
            <pc:sldMk cId="2948486128" sldId="256"/>
            <ac:cxnSpMk id="194" creationId="{F83F25F2-1FAA-4A5F-B409-43FFCE5B3E00}"/>
          </ac:cxnSpMkLst>
        </pc:cxnChg>
        <pc:cxnChg chg="mod">
          <ac:chgData name="藤崎 俊哉" userId="3a509560378e58bd" providerId="LiveId" clId="{2ABBADF9-FE45-454D-B6CE-1671F56E4272}" dt="2021-08-28T02:45:18.500" v="763" actId="1036"/>
          <ac:cxnSpMkLst>
            <pc:docMk/>
            <pc:sldMk cId="2948486128" sldId="256"/>
            <ac:cxnSpMk id="195" creationId="{201FFF33-D081-44B8-A155-E1CF1A98F553}"/>
          </ac:cxnSpMkLst>
        </pc:cxnChg>
      </pc:sldChg>
      <pc:sldMasterChg chg="modSp modSldLayout">
        <pc:chgData name="藤崎 俊哉" userId="3a509560378e58bd" providerId="LiveId" clId="{2ABBADF9-FE45-454D-B6CE-1671F56E4272}" dt="2021-08-28T02:21:19.127" v="278"/>
        <pc:sldMasterMkLst>
          <pc:docMk/>
          <pc:sldMasterMk cId="2949762497" sldId="2147483684"/>
        </pc:sldMasterMkLst>
        <pc:spChg chg="mod">
          <ac:chgData name="藤崎 俊哉" userId="3a509560378e58bd" providerId="LiveId" clId="{2ABBADF9-FE45-454D-B6CE-1671F56E4272}" dt="2021-08-28T02:21:19.127" v="278"/>
          <ac:spMkLst>
            <pc:docMk/>
            <pc:sldMasterMk cId="2949762497" sldId="2147483684"/>
            <ac:spMk id="2" creationId="{00000000-0000-0000-0000-000000000000}"/>
          </ac:spMkLst>
        </pc:spChg>
        <pc:spChg chg="mod">
          <ac:chgData name="藤崎 俊哉" userId="3a509560378e58bd" providerId="LiveId" clId="{2ABBADF9-FE45-454D-B6CE-1671F56E4272}" dt="2021-08-28T02:21:19.127" v="278"/>
          <ac:spMkLst>
            <pc:docMk/>
            <pc:sldMasterMk cId="2949762497" sldId="2147483684"/>
            <ac:spMk id="3" creationId="{00000000-0000-0000-0000-000000000000}"/>
          </ac:spMkLst>
        </pc:spChg>
        <pc:spChg chg="mod">
          <ac:chgData name="藤崎 俊哉" userId="3a509560378e58bd" providerId="LiveId" clId="{2ABBADF9-FE45-454D-B6CE-1671F56E4272}" dt="2021-08-28T02:21:19.127" v="278"/>
          <ac:spMkLst>
            <pc:docMk/>
            <pc:sldMasterMk cId="2949762497" sldId="2147483684"/>
            <ac:spMk id="4" creationId="{00000000-0000-0000-0000-000000000000}"/>
          </ac:spMkLst>
        </pc:spChg>
        <pc:spChg chg="mod">
          <ac:chgData name="藤崎 俊哉" userId="3a509560378e58bd" providerId="LiveId" clId="{2ABBADF9-FE45-454D-B6CE-1671F56E4272}" dt="2021-08-28T02:21:19.127" v="278"/>
          <ac:spMkLst>
            <pc:docMk/>
            <pc:sldMasterMk cId="2949762497" sldId="2147483684"/>
            <ac:spMk id="5" creationId="{00000000-0000-0000-0000-000000000000}"/>
          </ac:spMkLst>
        </pc:spChg>
        <pc:spChg chg="mod">
          <ac:chgData name="藤崎 俊哉" userId="3a509560378e58bd" providerId="LiveId" clId="{2ABBADF9-FE45-454D-B6CE-1671F56E4272}" dt="2021-08-28T02:21:19.127" v="278"/>
          <ac:spMkLst>
            <pc:docMk/>
            <pc:sldMasterMk cId="2949762497" sldId="2147483684"/>
            <ac:spMk id="6" creationId="{00000000-0000-0000-0000-000000000000}"/>
          </ac:spMkLst>
        </pc:spChg>
        <pc:sldLayoutChg chg="modSp">
          <pc:chgData name="藤崎 俊哉" userId="3a509560378e58bd" providerId="LiveId" clId="{2ABBADF9-FE45-454D-B6CE-1671F56E4272}" dt="2021-08-28T02:21:19.127" v="278"/>
          <pc:sldLayoutMkLst>
            <pc:docMk/>
            <pc:sldMasterMk cId="2949762497" sldId="2147483684"/>
            <pc:sldLayoutMk cId="3291433828" sldId="2147483685"/>
          </pc:sldLayoutMkLst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3291433828" sldId="2147483685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3291433828" sldId="2147483685"/>
              <ac:spMk id="3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21:19.127" v="278"/>
          <pc:sldLayoutMkLst>
            <pc:docMk/>
            <pc:sldMasterMk cId="2949762497" sldId="2147483684"/>
            <pc:sldLayoutMk cId="334614592" sldId="2147483687"/>
          </pc:sldLayoutMkLst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334614592" sldId="2147483687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334614592" sldId="2147483687"/>
              <ac:spMk id="3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21:19.127" v="278"/>
          <pc:sldLayoutMkLst>
            <pc:docMk/>
            <pc:sldMasterMk cId="2949762497" sldId="2147483684"/>
            <pc:sldLayoutMk cId="3275816690" sldId="2147483688"/>
          </pc:sldLayoutMkLst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3275816690" sldId="2147483688"/>
              <ac:spMk id="3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3275816690" sldId="2147483688"/>
              <ac:spMk id="4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21:19.127" v="278"/>
          <pc:sldLayoutMkLst>
            <pc:docMk/>
            <pc:sldMasterMk cId="2949762497" sldId="2147483684"/>
            <pc:sldLayoutMk cId="1069963962" sldId="2147483689"/>
          </pc:sldLayoutMkLst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1069963962" sldId="2147483689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1069963962" sldId="2147483689"/>
              <ac:spMk id="3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1069963962" sldId="2147483689"/>
              <ac:spMk id="4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1069963962" sldId="2147483689"/>
              <ac:spMk id="5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1069963962" sldId="2147483689"/>
              <ac:spMk id="6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21:19.127" v="278"/>
          <pc:sldLayoutMkLst>
            <pc:docMk/>
            <pc:sldMasterMk cId="2949762497" sldId="2147483684"/>
            <pc:sldLayoutMk cId="1196827414" sldId="2147483692"/>
          </pc:sldLayoutMkLst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1196827414" sldId="2147483692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1196827414" sldId="2147483692"/>
              <ac:spMk id="3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1196827414" sldId="2147483692"/>
              <ac:spMk id="4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21:19.127" v="278"/>
          <pc:sldLayoutMkLst>
            <pc:docMk/>
            <pc:sldMasterMk cId="2949762497" sldId="2147483684"/>
            <pc:sldLayoutMk cId="2922539010" sldId="2147483693"/>
          </pc:sldLayoutMkLst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2922539010" sldId="2147483693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2922539010" sldId="2147483693"/>
              <ac:spMk id="3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2922539010" sldId="2147483693"/>
              <ac:spMk id="4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21:19.127" v="278"/>
          <pc:sldLayoutMkLst>
            <pc:docMk/>
            <pc:sldMasterMk cId="2949762497" sldId="2147483684"/>
            <pc:sldLayoutMk cId="3352958783" sldId="2147483695"/>
          </pc:sldLayoutMkLst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3352958783" sldId="2147483695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21:19.127" v="278"/>
            <ac:spMkLst>
              <pc:docMk/>
              <pc:sldMasterMk cId="2949762497" sldId="2147483684"/>
              <pc:sldLayoutMk cId="3352958783" sldId="2147483695"/>
              <ac:spMk id="3" creationId="{00000000-0000-0000-0000-000000000000}"/>
            </ac:spMkLst>
          </pc:spChg>
        </pc:sldLayoutChg>
      </pc:sldMasterChg>
      <pc:sldMasterChg chg="modSp modSldLayout">
        <pc:chgData name="藤崎 俊哉" userId="3a509560378e58bd" providerId="LiveId" clId="{2ABBADF9-FE45-454D-B6CE-1671F56E4272}" dt="2021-08-28T02:44:42.021" v="736"/>
        <pc:sldMasterMkLst>
          <pc:docMk/>
          <pc:sldMasterMk cId="2146795363" sldId="2147483696"/>
        </pc:sldMasterMkLst>
        <pc:spChg chg="mod">
          <ac:chgData name="藤崎 俊哉" userId="3a509560378e58bd" providerId="LiveId" clId="{2ABBADF9-FE45-454D-B6CE-1671F56E4272}" dt="2021-08-28T02:44:42.021" v="736"/>
          <ac:spMkLst>
            <pc:docMk/>
            <pc:sldMasterMk cId="2146795363" sldId="2147483696"/>
            <ac:spMk id="2" creationId="{00000000-0000-0000-0000-000000000000}"/>
          </ac:spMkLst>
        </pc:spChg>
        <pc:spChg chg="mod">
          <ac:chgData name="藤崎 俊哉" userId="3a509560378e58bd" providerId="LiveId" clId="{2ABBADF9-FE45-454D-B6CE-1671F56E4272}" dt="2021-08-28T02:44:42.021" v="736"/>
          <ac:spMkLst>
            <pc:docMk/>
            <pc:sldMasterMk cId="2146795363" sldId="2147483696"/>
            <ac:spMk id="3" creationId="{00000000-0000-0000-0000-000000000000}"/>
          </ac:spMkLst>
        </pc:spChg>
        <pc:spChg chg="mod">
          <ac:chgData name="藤崎 俊哉" userId="3a509560378e58bd" providerId="LiveId" clId="{2ABBADF9-FE45-454D-B6CE-1671F56E4272}" dt="2021-08-28T02:44:42.021" v="736"/>
          <ac:spMkLst>
            <pc:docMk/>
            <pc:sldMasterMk cId="2146795363" sldId="2147483696"/>
            <ac:spMk id="4" creationId="{00000000-0000-0000-0000-000000000000}"/>
          </ac:spMkLst>
        </pc:spChg>
        <pc:spChg chg="mod">
          <ac:chgData name="藤崎 俊哉" userId="3a509560378e58bd" providerId="LiveId" clId="{2ABBADF9-FE45-454D-B6CE-1671F56E4272}" dt="2021-08-28T02:44:42.021" v="736"/>
          <ac:spMkLst>
            <pc:docMk/>
            <pc:sldMasterMk cId="2146795363" sldId="2147483696"/>
            <ac:spMk id="5" creationId="{00000000-0000-0000-0000-000000000000}"/>
          </ac:spMkLst>
        </pc:spChg>
        <pc:spChg chg="mod">
          <ac:chgData name="藤崎 俊哉" userId="3a509560378e58bd" providerId="LiveId" clId="{2ABBADF9-FE45-454D-B6CE-1671F56E4272}" dt="2021-08-28T02:44:42.021" v="736"/>
          <ac:spMkLst>
            <pc:docMk/>
            <pc:sldMasterMk cId="2146795363" sldId="2147483696"/>
            <ac:spMk id="6" creationId="{00000000-0000-0000-0000-000000000000}"/>
          </ac:spMkLst>
        </pc:spChg>
        <pc:sldLayoutChg chg="modSp">
          <pc:chgData name="藤崎 俊哉" userId="3a509560378e58bd" providerId="LiveId" clId="{2ABBADF9-FE45-454D-B6CE-1671F56E4272}" dt="2021-08-28T02:44:42.021" v="736"/>
          <pc:sldLayoutMkLst>
            <pc:docMk/>
            <pc:sldMasterMk cId="2146795363" sldId="2147483696"/>
            <pc:sldLayoutMk cId="2973390993" sldId="2147483697"/>
          </pc:sldLayoutMkLst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2973390993" sldId="2147483697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2973390993" sldId="2147483697"/>
              <ac:spMk id="3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44:42.021" v="736"/>
          <pc:sldLayoutMkLst>
            <pc:docMk/>
            <pc:sldMasterMk cId="2146795363" sldId="2147483696"/>
            <pc:sldLayoutMk cId="4178349663" sldId="2147483699"/>
          </pc:sldLayoutMkLst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4178349663" sldId="2147483699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4178349663" sldId="2147483699"/>
              <ac:spMk id="3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44:42.021" v="736"/>
          <pc:sldLayoutMkLst>
            <pc:docMk/>
            <pc:sldMasterMk cId="2146795363" sldId="2147483696"/>
            <pc:sldLayoutMk cId="2800707550" sldId="2147483700"/>
          </pc:sldLayoutMkLst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2800707550" sldId="2147483700"/>
              <ac:spMk id="3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2800707550" sldId="2147483700"/>
              <ac:spMk id="4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44:42.021" v="736"/>
          <pc:sldLayoutMkLst>
            <pc:docMk/>
            <pc:sldMasterMk cId="2146795363" sldId="2147483696"/>
            <pc:sldLayoutMk cId="1125316648" sldId="2147483701"/>
          </pc:sldLayoutMkLst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125316648" sldId="2147483701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125316648" sldId="2147483701"/>
              <ac:spMk id="3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125316648" sldId="2147483701"/>
              <ac:spMk id="4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125316648" sldId="2147483701"/>
              <ac:spMk id="5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125316648" sldId="2147483701"/>
              <ac:spMk id="6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44:42.021" v="736"/>
          <pc:sldLayoutMkLst>
            <pc:docMk/>
            <pc:sldMasterMk cId="2146795363" sldId="2147483696"/>
            <pc:sldLayoutMk cId="1737490525" sldId="2147483704"/>
          </pc:sldLayoutMkLst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737490525" sldId="2147483704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737490525" sldId="2147483704"/>
              <ac:spMk id="3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737490525" sldId="2147483704"/>
              <ac:spMk id="4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44:42.021" v="736"/>
          <pc:sldLayoutMkLst>
            <pc:docMk/>
            <pc:sldMasterMk cId="2146795363" sldId="2147483696"/>
            <pc:sldLayoutMk cId="3136095971" sldId="2147483705"/>
          </pc:sldLayoutMkLst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3136095971" sldId="2147483705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3136095971" sldId="2147483705"/>
              <ac:spMk id="3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3136095971" sldId="2147483705"/>
              <ac:spMk id="4" creationId="{00000000-0000-0000-0000-000000000000}"/>
            </ac:spMkLst>
          </pc:spChg>
        </pc:sldLayoutChg>
        <pc:sldLayoutChg chg="modSp">
          <pc:chgData name="藤崎 俊哉" userId="3a509560378e58bd" providerId="LiveId" clId="{2ABBADF9-FE45-454D-B6CE-1671F56E4272}" dt="2021-08-28T02:44:42.021" v="736"/>
          <pc:sldLayoutMkLst>
            <pc:docMk/>
            <pc:sldMasterMk cId="2146795363" sldId="2147483696"/>
            <pc:sldLayoutMk cId="1771659641" sldId="2147483707"/>
          </pc:sldLayoutMkLst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771659641" sldId="2147483707"/>
              <ac:spMk id="2" creationId="{00000000-0000-0000-0000-000000000000}"/>
            </ac:spMkLst>
          </pc:spChg>
          <pc:spChg chg="mod">
            <ac:chgData name="藤崎 俊哉" userId="3a509560378e58bd" providerId="LiveId" clId="{2ABBADF9-FE45-454D-B6CE-1671F56E4272}" dt="2021-08-28T02:44:42.021" v="736"/>
            <ac:spMkLst>
              <pc:docMk/>
              <pc:sldMasterMk cId="2146795363" sldId="2147483696"/>
              <pc:sldLayoutMk cId="1771659641" sldId="2147483707"/>
              <ac:spMk id="3" creationId="{00000000-0000-0000-0000-000000000000}"/>
            </ac:spMkLst>
          </pc:spChg>
        </pc:sldLayoutChg>
      </pc:sldMasterChg>
    </pc:docChg>
  </pc:docChgLst>
  <pc:docChgLst>
    <pc:chgData name="Watanabe Satoshi" userId="ca2b3ca5d2e030cf" providerId="LiveId" clId="{8C1D7E79-AF93-430E-92C1-5FFF47833A42}"/>
    <pc:docChg chg="undo redo custSel modSld">
      <pc:chgData name="Watanabe Satoshi" userId="ca2b3ca5d2e030cf" providerId="LiveId" clId="{8C1D7E79-AF93-430E-92C1-5FFF47833A42}" dt="2021-08-29T02:27:43.473" v="103" actId="1035"/>
      <pc:docMkLst>
        <pc:docMk/>
      </pc:docMkLst>
      <pc:sldChg chg="modSp mod">
        <pc:chgData name="Watanabe Satoshi" userId="ca2b3ca5d2e030cf" providerId="LiveId" clId="{8C1D7E79-AF93-430E-92C1-5FFF47833A42}" dt="2021-08-29T02:27:43.473" v="103" actId="1035"/>
        <pc:sldMkLst>
          <pc:docMk/>
          <pc:sldMk cId="2948486128" sldId="256"/>
        </pc:sldMkLst>
        <pc:spChg chg="mod">
          <ac:chgData name="Watanabe Satoshi" userId="ca2b3ca5d2e030cf" providerId="LiveId" clId="{8C1D7E79-AF93-430E-92C1-5FFF47833A42}" dt="2021-08-28T03:52:13.955" v="2" actId="20577"/>
          <ac:spMkLst>
            <pc:docMk/>
            <pc:sldMk cId="2948486128" sldId="256"/>
            <ac:spMk id="31" creationId="{A3AF4D88-E400-4C19-B94D-82E140AF90C4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32" creationId="{00991F26-2F59-43B3-8EE5-E257BDA222B2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33" creationId="{0FBE97C3-46EE-4DE3-AE33-61FF125F5CAA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34" creationId="{E3687B74-3E33-4097-BE09-E5E5B5B0A9C0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35" creationId="{5E1FA7B8-6962-4F7D-8767-C716DFB3878E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36" creationId="{9F9E805E-0E09-4E2E-9093-C10A8F61EC65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37" creationId="{091BB1DA-1D99-40AA-B42C-06F8F8574B13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38" creationId="{F568EF79-ED3A-4AC8-9218-E565FDCCD51D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39" creationId="{BC2EFD59-F1E9-431B-B9B2-3DB39DAF9EE8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40" creationId="{FC96A51E-12E9-410C-9076-D51DB7FB1E44}"/>
          </ac:spMkLst>
        </pc:spChg>
        <pc:spChg chg="mod">
          <ac:chgData name="Watanabe Satoshi" userId="ca2b3ca5d2e030cf" providerId="LiveId" clId="{8C1D7E79-AF93-430E-92C1-5FFF47833A42}" dt="2021-08-29T02:27:35.138" v="99" actId="14100"/>
          <ac:spMkLst>
            <pc:docMk/>
            <pc:sldMk cId="2948486128" sldId="256"/>
            <ac:spMk id="41" creationId="{CA030166-5B51-4B78-8F78-A23BC4330BA7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66" creationId="{11516493-97E9-4BAF-8E84-76ECF8050606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68" creationId="{E52B28A1-A923-445E-B5D4-3C3E0A2F4D1E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44" creationId="{D211C5E8-B412-44A9-A4F0-F33242D1599E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50" creationId="{B2DCE32E-1D1D-4EA9-9FA3-9EF93AAE70B6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52" creationId="{F8CC6286-56E6-460B-81E9-4341F6EFD847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54" creationId="{DFC29438-7775-44AD-9FFC-E6EED2AEFE78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56" creationId="{4121DD79-7C0E-4179-BCD5-9B2D10D11453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58" creationId="{2BABB285-24E7-4BA3-A2C5-BCF2172F0527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60" creationId="{55869DFA-B67F-402C-B5FC-940BC4322366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62" creationId="{F45D1759-436C-4D6E-9147-B964DF8E7D67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64" creationId="{6C7E508B-140B-48AF-BB15-10B8DC43DD37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66" creationId="{29861061-9AE4-4C74-A73A-4EE942B3D37F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68" creationId="{1A84CC83-5DA6-48F3-A2A7-39E8FCF87229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70" creationId="{AB2797B4-88DC-4537-B9C0-531B263D5059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72" creationId="{BAF923C9-5D37-459E-BA0C-194A60964211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74" creationId="{71953143-7837-42EC-B07D-DA5539E99B53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76" creationId="{C30B962C-E610-4097-AC4D-9E7709B77464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78" creationId="{628B0AD0-9982-44A6-B031-7EC27A00C6AD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80" creationId="{0069E8C7-C6A2-47BB-863E-B5290B541664}"/>
          </ac:spMkLst>
        </pc:spChg>
        <pc:spChg chg="mod">
          <ac:chgData name="Watanabe Satoshi" userId="ca2b3ca5d2e030cf" providerId="LiveId" clId="{8C1D7E79-AF93-430E-92C1-5FFF47833A42}" dt="2021-08-29T02:27:43.473" v="103" actId="1035"/>
          <ac:spMkLst>
            <pc:docMk/>
            <pc:sldMk cId="2948486128" sldId="256"/>
            <ac:spMk id="182" creationId="{B84FE761-7571-4753-8D0B-B709D7F03772}"/>
          </ac:spMkLst>
        </pc:spChg>
        <pc:spChg chg="mod">
          <ac:chgData name="Watanabe Satoshi" userId="ca2b3ca5d2e030cf" providerId="LiveId" clId="{8C1D7E79-AF93-430E-92C1-5FFF47833A42}" dt="2021-08-29T01:14:27.795" v="70" actId="1038"/>
          <ac:spMkLst>
            <pc:docMk/>
            <pc:sldMk cId="2948486128" sldId="256"/>
            <ac:spMk id="197" creationId="{98056808-983E-45C2-BC73-CAA14417FC88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9373367254768761E-2"/>
          <c:y val="1.8203320521266567E-2"/>
          <c:w val="0.93246762375725589"/>
          <c:h val="0.91978506715344932"/>
        </c:manualLayout>
      </c:layout>
      <c:scatterChart>
        <c:scatterStyle val="lineMarker"/>
        <c:varyColors val="0"/>
        <c:ser>
          <c:idx val="0"/>
          <c:order val="0"/>
          <c:tx>
            <c:v>継続</c:v>
          </c:tx>
          <c:spPr>
            <a:ln w="38100">
              <a:solidFill>
                <a:schemeClr val="accent6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00-15D5-4EB8-B234-411324FFB9B4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01-15D5-4EB8-B234-411324FFB9B4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02-15D5-4EB8-B234-411324FFB9B4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03-15D5-4EB8-B234-411324FFB9B4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04-15D5-4EB8-B234-411324FFB9B4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05-15D5-4EB8-B234-411324FFB9B4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06-15D5-4EB8-B234-411324FFB9B4}"/>
              </c:ext>
            </c:extLst>
          </c:dPt>
          <c:dPt>
            <c:idx val="8"/>
            <c:bubble3D val="0"/>
            <c:extLst>
              <c:ext xmlns:c16="http://schemas.microsoft.com/office/drawing/2014/chart" uri="{C3380CC4-5D6E-409C-BE32-E72D297353CC}">
                <c16:uniqueId val="{00000007-15D5-4EB8-B234-411324FFB9B4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08-15D5-4EB8-B234-411324FFB9B4}"/>
              </c:ext>
            </c:extLst>
          </c:dPt>
          <c:dPt>
            <c:idx val="10"/>
            <c:bubble3D val="0"/>
            <c:extLst>
              <c:ext xmlns:c16="http://schemas.microsoft.com/office/drawing/2014/chart" uri="{C3380CC4-5D6E-409C-BE32-E72D297353CC}">
                <c16:uniqueId val="{00000009-15D5-4EB8-B234-411324FFB9B4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0A-15D5-4EB8-B234-411324FFB9B4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0B-15D5-4EB8-B234-411324FFB9B4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0C-15D5-4EB8-B234-411324FFB9B4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0D-15D5-4EB8-B234-411324FFB9B4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0E-15D5-4EB8-B234-411324FFB9B4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0F-15D5-4EB8-B234-411324FFB9B4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10-15D5-4EB8-B234-411324FFB9B4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11-15D5-4EB8-B234-411324FFB9B4}"/>
              </c:ext>
            </c:extLst>
          </c:dPt>
          <c:dPt>
            <c:idx val="20"/>
            <c:bubble3D val="0"/>
            <c:extLst>
              <c:ext xmlns:c16="http://schemas.microsoft.com/office/drawing/2014/chart" uri="{C3380CC4-5D6E-409C-BE32-E72D297353CC}">
                <c16:uniqueId val="{00000012-15D5-4EB8-B234-411324FFB9B4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13-15D5-4EB8-B234-411324FFB9B4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14-15D5-4EB8-B234-411324FFB9B4}"/>
              </c:ext>
            </c:extLst>
          </c:dPt>
          <c:dPt>
            <c:idx val="23"/>
            <c:bubble3D val="0"/>
            <c:extLst>
              <c:ext xmlns:c16="http://schemas.microsoft.com/office/drawing/2014/chart" uri="{C3380CC4-5D6E-409C-BE32-E72D297353CC}">
                <c16:uniqueId val="{00000015-15D5-4EB8-B234-411324FFB9B4}"/>
              </c:ext>
            </c:extLst>
          </c:dPt>
          <c:dPt>
            <c:idx val="24"/>
            <c:bubble3D val="0"/>
            <c:extLst>
              <c:ext xmlns:c16="http://schemas.microsoft.com/office/drawing/2014/chart" uri="{C3380CC4-5D6E-409C-BE32-E72D297353CC}">
                <c16:uniqueId val="{00000016-15D5-4EB8-B234-411324FFB9B4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17-15D5-4EB8-B234-411324FFB9B4}"/>
              </c:ext>
            </c:extLst>
          </c:dPt>
          <c:dPt>
            <c:idx val="26"/>
            <c:bubble3D val="0"/>
            <c:extLst>
              <c:ext xmlns:c16="http://schemas.microsoft.com/office/drawing/2014/chart" uri="{C3380CC4-5D6E-409C-BE32-E72D297353CC}">
                <c16:uniqueId val="{00000018-15D5-4EB8-B234-411324FFB9B4}"/>
              </c:ext>
            </c:extLst>
          </c:dPt>
          <c:dPt>
            <c:idx val="27"/>
            <c:bubble3D val="0"/>
            <c:extLst>
              <c:ext xmlns:c16="http://schemas.microsoft.com/office/drawing/2014/chart" uri="{C3380CC4-5D6E-409C-BE32-E72D297353CC}">
                <c16:uniqueId val="{00000019-15D5-4EB8-B234-411324FFB9B4}"/>
              </c:ext>
            </c:extLst>
          </c:dPt>
          <c:dPt>
            <c:idx val="29"/>
            <c:bubble3D val="0"/>
            <c:extLst>
              <c:ext xmlns:c16="http://schemas.microsoft.com/office/drawing/2014/chart" uri="{C3380CC4-5D6E-409C-BE32-E72D297353CC}">
                <c16:uniqueId val="{0000001A-15D5-4EB8-B234-411324FFB9B4}"/>
              </c:ext>
            </c:extLst>
          </c:dPt>
          <c:dPt>
            <c:idx val="30"/>
            <c:bubble3D val="0"/>
            <c:extLst>
              <c:ext xmlns:c16="http://schemas.microsoft.com/office/drawing/2014/chart" uri="{C3380CC4-5D6E-409C-BE32-E72D297353CC}">
                <c16:uniqueId val="{0000001B-15D5-4EB8-B234-411324FFB9B4}"/>
              </c:ext>
            </c:extLst>
          </c:dPt>
          <c:dPt>
            <c:idx val="31"/>
            <c:bubble3D val="0"/>
            <c:extLst>
              <c:ext xmlns:c16="http://schemas.microsoft.com/office/drawing/2014/chart" uri="{C3380CC4-5D6E-409C-BE32-E72D297353CC}">
                <c16:uniqueId val="{0000001C-15D5-4EB8-B234-411324FFB9B4}"/>
              </c:ext>
            </c:extLst>
          </c:dPt>
          <c:dPt>
            <c:idx val="32"/>
            <c:bubble3D val="0"/>
            <c:extLst>
              <c:ext xmlns:c16="http://schemas.microsoft.com/office/drawing/2014/chart" uri="{C3380CC4-5D6E-409C-BE32-E72D297353CC}">
                <c16:uniqueId val="{0000001D-15D5-4EB8-B234-411324FFB9B4}"/>
              </c:ext>
            </c:extLst>
          </c:dPt>
          <c:dPt>
            <c:idx val="33"/>
            <c:bubble3D val="0"/>
            <c:extLst>
              <c:ext xmlns:c16="http://schemas.microsoft.com/office/drawing/2014/chart" uri="{C3380CC4-5D6E-409C-BE32-E72D297353CC}">
                <c16:uniqueId val="{0000001E-15D5-4EB8-B234-411324FFB9B4}"/>
              </c:ext>
            </c:extLst>
          </c:dPt>
          <c:dPt>
            <c:idx val="34"/>
            <c:bubble3D val="0"/>
            <c:extLst>
              <c:ext xmlns:c16="http://schemas.microsoft.com/office/drawing/2014/chart" uri="{C3380CC4-5D6E-409C-BE32-E72D297353CC}">
                <c16:uniqueId val="{0000001F-15D5-4EB8-B234-411324FFB9B4}"/>
              </c:ext>
            </c:extLst>
          </c:dPt>
          <c:dPt>
            <c:idx val="35"/>
            <c:bubble3D val="0"/>
            <c:extLst>
              <c:ext xmlns:c16="http://schemas.microsoft.com/office/drawing/2014/chart" uri="{C3380CC4-5D6E-409C-BE32-E72D297353CC}">
                <c16:uniqueId val="{00000020-15D5-4EB8-B234-411324FFB9B4}"/>
              </c:ext>
            </c:extLst>
          </c:dPt>
          <c:dPt>
            <c:idx val="36"/>
            <c:bubble3D val="0"/>
            <c:extLst>
              <c:ext xmlns:c16="http://schemas.microsoft.com/office/drawing/2014/chart" uri="{C3380CC4-5D6E-409C-BE32-E72D297353CC}">
                <c16:uniqueId val="{00000021-15D5-4EB8-B234-411324FFB9B4}"/>
              </c:ext>
            </c:extLst>
          </c:dPt>
          <c:dPt>
            <c:idx val="37"/>
            <c:bubble3D val="0"/>
            <c:extLst>
              <c:ext xmlns:c16="http://schemas.microsoft.com/office/drawing/2014/chart" uri="{C3380CC4-5D6E-409C-BE32-E72D297353CC}">
                <c16:uniqueId val="{00000022-15D5-4EB8-B234-411324FFB9B4}"/>
              </c:ext>
            </c:extLst>
          </c:dPt>
          <c:dPt>
            <c:idx val="38"/>
            <c:bubble3D val="0"/>
            <c:extLst>
              <c:ext xmlns:c16="http://schemas.microsoft.com/office/drawing/2014/chart" uri="{C3380CC4-5D6E-409C-BE32-E72D297353CC}">
                <c16:uniqueId val="{00000023-15D5-4EB8-B234-411324FFB9B4}"/>
              </c:ext>
            </c:extLst>
          </c:dPt>
          <c:dPt>
            <c:idx val="39"/>
            <c:bubble3D val="0"/>
            <c:extLst>
              <c:ext xmlns:c16="http://schemas.microsoft.com/office/drawing/2014/chart" uri="{C3380CC4-5D6E-409C-BE32-E72D297353CC}">
                <c16:uniqueId val="{00000024-15D5-4EB8-B234-411324FFB9B4}"/>
              </c:ext>
            </c:extLst>
          </c:dPt>
          <c:dPt>
            <c:idx val="40"/>
            <c:bubble3D val="0"/>
            <c:extLst>
              <c:ext xmlns:c16="http://schemas.microsoft.com/office/drawing/2014/chart" uri="{C3380CC4-5D6E-409C-BE32-E72D297353CC}">
                <c16:uniqueId val="{00000025-15D5-4EB8-B234-411324FFB9B4}"/>
              </c:ext>
            </c:extLst>
          </c:dPt>
          <c:dPt>
            <c:idx val="41"/>
            <c:bubble3D val="0"/>
            <c:extLst>
              <c:ext xmlns:c16="http://schemas.microsoft.com/office/drawing/2014/chart" uri="{C3380CC4-5D6E-409C-BE32-E72D297353CC}">
                <c16:uniqueId val="{00000026-15D5-4EB8-B234-411324FFB9B4}"/>
              </c:ext>
            </c:extLst>
          </c:dPt>
          <c:dPt>
            <c:idx val="42"/>
            <c:bubble3D val="0"/>
            <c:extLst>
              <c:ext xmlns:c16="http://schemas.microsoft.com/office/drawing/2014/chart" uri="{C3380CC4-5D6E-409C-BE32-E72D297353CC}">
                <c16:uniqueId val="{00000027-15D5-4EB8-B234-411324FFB9B4}"/>
              </c:ext>
            </c:extLst>
          </c:dPt>
          <c:dPt>
            <c:idx val="43"/>
            <c:bubble3D val="0"/>
            <c:extLst>
              <c:ext xmlns:c16="http://schemas.microsoft.com/office/drawing/2014/chart" uri="{C3380CC4-5D6E-409C-BE32-E72D297353CC}">
                <c16:uniqueId val="{00000028-15D5-4EB8-B234-411324FFB9B4}"/>
              </c:ext>
            </c:extLst>
          </c:dPt>
          <c:dPt>
            <c:idx val="44"/>
            <c:bubble3D val="0"/>
            <c:extLst>
              <c:ext xmlns:c16="http://schemas.microsoft.com/office/drawing/2014/chart" uri="{C3380CC4-5D6E-409C-BE32-E72D297353CC}">
                <c16:uniqueId val="{00000029-15D5-4EB8-B234-411324FFB9B4}"/>
              </c:ext>
            </c:extLst>
          </c:dPt>
          <c:dPt>
            <c:idx val="45"/>
            <c:bubble3D val="0"/>
            <c:extLst>
              <c:ext xmlns:c16="http://schemas.microsoft.com/office/drawing/2014/chart" uri="{C3380CC4-5D6E-409C-BE32-E72D297353CC}">
                <c16:uniqueId val="{0000002A-15D5-4EB8-B234-411324FFB9B4}"/>
              </c:ext>
            </c:extLst>
          </c:dPt>
          <c:dPt>
            <c:idx val="46"/>
            <c:bubble3D val="0"/>
            <c:extLst>
              <c:ext xmlns:c16="http://schemas.microsoft.com/office/drawing/2014/chart" uri="{C3380CC4-5D6E-409C-BE32-E72D297353CC}">
                <c16:uniqueId val="{0000002B-15D5-4EB8-B234-411324FFB9B4}"/>
              </c:ext>
            </c:extLst>
          </c:dPt>
          <c:dPt>
            <c:idx val="47"/>
            <c:bubble3D val="0"/>
            <c:extLst>
              <c:ext xmlns:c16="http://schemas.microsoft.com/office/drawing/2014/chart" uri="{C3380CC4-5D6E-409C-BE32-E72D297353CC}">
                <c16:uniqueId val="{0000002C-15D5-4EB8-B234-411324FFB9B4}"/>
              </c:ext>
            </c:extLst>
          </c:dPt>
          <c:dPt>
            <c:idx val="48"/>
            <c:bubble3D val="0"/>
            <c:extLst>
              <c:ext xmlns:c16="http://schemas.microsoft.com/office/drawing/2014/chart" uri="{C3380CC4-5D6E-409C-BE32-E72D297353CC}">
                <c16:uniqueId val="{0000002D-15D5-4EB8-B234-411324FFB9B4}"/>
              </c:ext>
            </c:extLst>
          </c:dPt>
          <c:dPt>
            <c:idx val="49"/>
            <c:bubble3D val="0"/>
            <c:extLst>
              <c:ext xmlns:c16="http://schemas.microsoft.com/office/drawing/2014/chart" uri="{C3380CC4-5D6E-409C-BE32-E72D297353CC}">
                <c16:uniqueId val="{0000002E-15D5-4EB8-B234-411324FFB9B4}"/>
              </c:ext>
            </c:extLst>
          </c:dPt>
          <c:dPt>
            <c:idx val="50"/>
            <c:bubble3D val="0"/>
            <c:extLst>
              <c:ext xmlns:c16="http://schemas.microsoft.com/office/drawing/2014/chart" uri="{C3380CC4-5D6E-409C-BE32-E72D297353CC}">
                <c16:uniqueId val="{0000002F-15D5-4EB8-B234-411324FFB9B4}"/>
              </c:ext>
            </c:extLst>
          </c:dPt>
          <c:dPt>
            <c:idx val="51"/>
            <c:bubble3D val="0"/>
            <c:extLst>
              <c:ext xmlns:c16="http://schemas.microsoft.com/office/drawing/2014/chart" uri="{C3380CC4-5D6E-409C-BE32-E72D297353CC}">
                <c16:uniqueId val="{00000030-15D5-4EB8-B234-411324FFB9B4}"/>
              </c:ext>
            </c:extLst>
          </c:dPt>
          <c:dPt>
            <c:idx val="52"/>
            <c:bubble3D val="0"/>
            <c:extLst>
              <c:ext xmlns:c16="http://schemas.microsoft.com/office/drawing/2014/chart" uri="{C3380CC4-5D6E-409C-BE32-E72D297353CC}">
                <c16:uniqueId val="{00000031-15D5-4EB8-B234-411324FFB9B4}"/>
              </c:ext>
            </c:extLst>
          </c:dPt>
          <c:dPt>
            <c:idx val="53"/>
            <c:bubble3D val="0"/>
            <c:extLst>
              <c:ext xmlns:c16="http://schemas.microsoft.com/office/drawing/2014/chart" uri="{C3380CC4-5D6E-409C-BE32-E72D297353CC}">
                <c16:uniqueId val="{00000032-15D5-4EB8-B234-411324FFB9B4}"/>
              </c:ext>
            </c:extLst>
          </c:dPt>
          <c:dPt>
            <c:idx val="54"/>
            <c:bubble3D val="0"/>
            <c:extLst>
              <c:ext xmlns:c16="http://schemas.microsoft.com/office/drawing/2014/chart" uri="{C3380CC4-5D6E-409C-BE32-E72D297353CC}">
                <c16:uniqueId val="{00000033-15D5-4EB8-B234-411324FFB9B4}"/>
              </c:ext>
            </c:extLst>
          </c:dPt>
          <c:dPt>
            <c:idx val="55"/>
            <c:bubble3D val="0"/>
            <c:extLst>
              <c:ext xmlns:c16="http://schemas.microsoft.com/office/drawing/2014/chart" uri="{C3380CC4-5D6E-409C-BE32-E72D297353CC}">
                <c16:uniqueId val="{00000034-15D5-4EB8-B234-411324FFB9B4}"/>
              </c:ext>
            </c:extLst>
          </c:dPt>
          <c:dPt>
            <c:idx val="56"/>
            <c:bubble3D val="0"/>
            <c:extLst>
              <c:ext xmlns:c16="http://schemas.microsoft.com/office/drawing/2014/chart" uri="{C3380CC4-5D6E-409C-BE32-E72D297353CC}">
                <c16:uniqueId val="{00000035-15D5-4EB8-B234-411324FFB9B4}"/>
              </c:ext>
            </c:extLst>
          </c:dPt>
          <c:dPt>
            <c:idx val="57"/>
            <c:bubble3D val="0"/>
            <c:extLst>
              <c:ext xmlns:c16="http://schemas.microsoft.com/office/drawing/2014/chart" uri="{C3380CC4-5D6E-409C-BE32-E72D297353CC}">
                <c16:uniqueId val="{00000036-15D5-4EB8-B234-411324FFB9B4}"/>
              </c:ext>
            </c:extLst>
          </c:dPt>
          <c:dPt>
            <c:idx val="58"/>
            <c:bubble3D val="0"/>
            <c:extLst>
              <c:ext xmlns:c16="http://schemas.microsoft.com/office/drawing/2014/chart" uri="{C3380CC4-5D6E-409C-BE32-E72D297353CC}">
                <c16:uniqueId val="{00000037-15D5-4EB8-B234-411324FFB9B4}"/>
              </c:ext>
            </c:extLst>
          </c:dPt>
          <c:dPt>
            <c:idx val="59"/>
            <c:bubble3D val="0"/>
            <c:extLst>
              <c:ext xmlns:c16="http://schemas.microsoft.com/office/drawing/2014/chart" uri="{C3380CC4-5D6E-409C-BE32-E72D297353CC}">
                <c16:uniqueId val="{00000038-15D5-4EB8-B234-411324FFB9B4}"/>
              </c:ext>
            </c:extLst>
          </c:dPt>
          <c:dPt>
            <c:idx val="60"/>
            <c:bubble3D val="0"/>
            <c:extLst>
              <c:ext xmlns:c16="http://schemas.microsoft.com/office/drawing/2014/chart" uri="{C3380CC4-5D6E-409C-BE32-E72D297353CC}">
                <c16:uniqueId val="{00000039-15D5-4EB8-B234-411324FFB9B4}"/>
              </c:ext>
            </c:extLst>
          </c:dPt>
          <c:dPt>
            <c:idx val="61"/>
            <c:bubble3D val="0"/>
            <c:extLst>
              <c:ext xmlns:c16="http://schemas.microsoft.com/office/drawing/2014/chart" uri="{C3380CC4-5D6E-409C-BE32-E72D297353CC}">
                <c16:uniqueId val="{0000003A-15D5-4EB8-B234-411324FFB9B4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1!$I$7:$I$68</c:f>
                <c:numCache>
                  <c:formatCode>General</c:formatCode>
                  <c:ptCount val="62"/>
                  <c:pt idx="0">
                    <c:v>0</c:v>
                  </c:pt>
                  <c:pt idx="1">
                    <c:v>3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  <c:pt idx="7">
                    <c:v>3</c:v>
                  </c:pt>
                  <c:pt idx="8">
                    <c:v>0</c:v>
                  </c:pt>
                  <c:pt idx="9">
                    <c:v>3</c:v>
                  </c:pt>
                  <c:pt idx="10">
                    <c:v>0</c:v>
                  </c:pt>
                  <c:pt idx="11">
                    <c:v>3</c:v>
                  </c:pt>
                  <c:pt idx="12">
                    <c:v>0</c:v>
                  </c:pt>
                  <c:pt idx="13">
                    <c:v>3</c:v>
                  </c:pt>
                  <c:pt idx="14">
                    <c:v>0</c:v>
                  </c:pt>
                  <c:pt idx="15">
                    <c:v>0</c:v>
                  </c:pt>
                  <c:pt idx="16">
                    <c:v>0</c:v>
                  </c:pt>
                  <c:pt idx="17">
                    <c:v>3</c:v>
                  </c:pt>
                  <c:pt idx="18">
                    <c:v>0</c:v>
                  </c:pt>
                  <c:pt idx="19">
                    <c:v>3</c:v>
                  </c:pt>
                  <c:pt idx="20">
                    <c:v>0</c:v>
                  </c:pt>
                  <c:pt idx="21">
                    <c:v>3</c:v>
                  </c:pt>
                  <c:pt idx="22">
                    <c:v>0</c:v>
                  </c:pt>
                  <c:pt idx="23">
                    <c:v>3</c:v>
                  </c:pt>
                  <c:pt idx="24">
                    <c:v>0</c:v>
                  </c:pt>
                  <c:pt idx="25">
                    <c:v>3</c:v>
                  </c:pt>
                  <c:pt idx="26">
                    <c:v>0</c:v>
                  </c:pt>
                  <c:pt idx="27">
                    <c:v>0</c:v>
                  </c:pt>
                  <c:pt idx="28">
                    <c:v>0</c:v>
                  </c:pt>
                  <c:pt idx="29">
                    <c:v>3</c:v>
                  </c:pt>
                  <c:pt idx="30">
                    <c:v>0</c:v>
                  </c:pt>
                  <c:pt idx="31">
                    <c:v>3</c:v>
                  </c:pt>
                  <c:pt idx="32">
                    <c:v>3</c:v>
                  </c:pt>
                  <c:pt idx="33">
                    <c:v>0</c:v>
                  </c:pt>
                  <c:pt idx="34">
                    <c:v>3</c:v>
                  </c:pt>
                  <c:pt idx="35">
                    <c:v>0</c:v>
                  </c:pt>
                  <c:pt idx="36">
                    <c:v>3</c:v>
                  </c:pt>
                  <c:pt idx="37">
                    <c:v>0</c:v>
                  </c:pt>
                  <c:pt idx="38">
                    <c:v>3</c:v>
                  </c:pt>
                  <c:pt idx="39">
                    <c:v>0</c:v>
                  </c:pt>
                  <c:pt idx="40">
                    <c:v>3</c:v>
                  </c:pt>
                  <c:pt idx="41">
                    <c:v>0</c:v>
                  </c:pt>
                  <c:pt idx="42">
                    <c:v>3</c:v>
                  </c:pt>
                  <c:pt idx="43">
                    <c:v>0</c:v>
                  </c:pt>
                  <c:pt idx="44">
                    <c:v>3</c:v>
                  </c:pt>
                  <c:pt idx="45">
                    <c:v>0</c:v>
                  </c:pt>
                  <c:pt idx="46">
                    <c:v>3</c:v>
                  </c:pt>
                  <c:pt idx="47">
                    <c:v>0</c:v>
                  </c:pt>
                  <c:pt idx="48">
                    <c:v>3</c:v>
                  </c:pt>
                  <c:pt idx="49">
                    <c:v>0</c:v>
                  </c:pt>
                  <c:pt idx="50">
                    <c:v>3</c:v>
                  </c:pt>
                  <c:pt idx="51">
                    <c:v>0</c:v>
                  </c:pt>
                  <c:pt idx="52">
                    <c:v>3</c:v>
                  </c:pt>
                  <c:pt idx="53">
                    <c:v>0</c:v>
                  </c:pt>
                  <c:pt idx="54">
                    <c:v>3</c:v>
                  </c:pt>
                  <c:pt idx="55">
                    <c:v>0</c:v>
                  </c:pt>
                  <c:pt idx="56">
                    <c:v>3</c:v>
                  </c:pt>
                  <c:pt idx="57">
                    <c:v>0</c:v>
                  </c:pt>
                  <c:pt idx="58">
                    <c:v>3</c:v>
                  </c:pt>
                  <c:pt idx="59">
                    <c:v>0</c:v>
                  </c:pt>
                  <c:pt idx="60">
                    <c:v>3</c:v>
                  </c:pt>
                  <c:pt idx="61">
                    <c:v>0</c:v>
                  </c:pt>
                </c:numCache>
              </c:numRef>
            </c:plus>
          </c:errBars>
          <c:xVal>
            <c:numRef>
              <c:f>Kaplan1!$G$7:$G$68</c:f>
              <c:numCache>
                <c:formatCode>0.000</c:formatCode>
                <c:ptCount val="62"/>
                <c:pt idx="0">
                  <c:v>0</c:v>
                </c:pt>
                <c:pt idx="1">
                  <c:v>5.6785714285714288</c:v>
                </c:pt>
                <c:pt idx="2">
                  <c:v>5.6785714285714288</c:v>
                </c:pt>
                <c:pt idx="3">
                  <c:v>6.6428571428571432</c:v>
                </c:pt>
                <c:pt idx="4">
                  <c:v>6.6428571428571432</c:v>
                </c:pt>
                <c:pt idx="5">
                  <c:v>6.9642857142857144</c:v>
                </c:pt>
                <c:pt idx="6">
                  <c:v>6.9642857142857144</c:v>
                </c:pt>
                <c:pt idx="7">
                  <c:v>7.4285714285714288</c:v>
                </c:pt>
                <c:pt idx="8">
                  <c:v>7.4285714285714288</c:v>
                </c:pt>
                <c:pt idx="9">
                  <c:v>8.2857142857142865</c:v>
                </c:pt>
                <c:pt idx="10">
                  <c:v>8.2857142857142865</c:v>
                </c:pt>
                <c:pt idx="11">
                  <c:v>8.5</c:v>
                </c:pt>
                <c:pt idx="12">
                  <c:v>8.5</c:v>
                </c:pt>
                <c:pt idx="13">
                  <c:v>9</c:v>
                </c:pt>
                <c:pt idx="14">
                  <c:v>9</c:v>
                </c:pt>
                <c:pt idx="15">
                  <c:v>10.214285714285714</c:v>
                </c:pt>
                <c:pt idx="16">
                  <c:v>10.214285714285714</c:v>
                </c:pt>
                <c:pt idx="17">
                  <c:v>10.75</c:v>
                </c:pt>
                <c:pt idx="18">
                  <c:v>10.75</c:v>
                </c:pt>
                <c:pt idx="19">
                  <c:v>11.035714285714286</c:v>
                </c:pt>
                <c:pt idx="20">
                  <c:v>11.035714285714286</c:v>
                </c:pt>
                <c:pt idx="21">
                  <c:v>11.571428571428571</c:v>
                </c:pt>
                <c:pt idx="22">
                  <c:v>11.571428571428571</c:v>
                </c:pt>
                <c:pt idx="23">
                  <c:v>12.25</c:v>
                </c:pt>
                <c:pt idx="24">
                  <c:v>12.25</c:v>
                </c:pt>
                <c:pt idx="25">
                  <c:v>14.035714285714286</c:v>
                </c:pt>
                <c:pt idx="26">
                  <c:v>14.035714285714286</c:v>
                </c:pt>
                <c:pt idx="27">
                  <c:v>14.178571428571429</c:v>
                </c:pt>
                <c:pt idx="28">
                  <c:v>14.178571428571429</c:v>
                </c:pt>
                <c:pt idx="29">
                  <c:v>14.5</c:v>
                </c:pt>
                <c:pt idx="30">
                  <c:v>14.5</c:v>
                </c:pt>
                <c:pt idx="31">
                  <c:v>14.698928571428572</c:v>
                </c:pt>
                <c:pt idx="32">
                  <c:v>14.857142857142858</c:v>
                </c:pt>
                <c:pt idx="33">
                  <c:v>14.857142857142858</c:v>
                </c:pt>
                <c:pt idx="34">
                  <c:v>15.25</c:v>
                </c:pt>
                <c:pt idx="35">
                  <c:v>15.25</c:v>
                </c:pt>
                <c:pt idx="36">
                  <c:v>15.714285714285714</c:v>
                </c:pt>
                <c:pt idx="37">
                  <c:v>15.714285714285714</c:v>
                </c:pt>
                <c:pt idx="38">
                  <c:v>16.5</c:v>
                </c:pt>
                <c:pt idx="39">
                  <c:v>16.5</c:v>
                </c:pt>
                <c:pt idx="40">
                  <c:v>17.142857142857142</c:v>
                </c:pt>
                <c:pt idx="41">
                  <c:v>17.142857142857142</c:v>
                </c:pt>
                <c:pt idx="42">
                  <c:v>17.821428571428573</c:v>
                </c:pt>
                <c:pt idx="43">
                  <c:v>17.821428571428573</c:v>
                </c:pt>
                <c:pt idx="44">
                  <c:v>22.25</c:v>
                </c:pt>
                <c:pt idx="45">
                  <c:v>22.25</c:v>
                </c:pt>
                <c:pt idx="46">
                  <c:v>22.642857142857142</c:v>
                </c:pt>
                <c:pt idx="47">
                  <c:v>22.642857142857142</c:v>
                </c:pt>
                <c:pt idx="48">
                  <c:v>23.428571428571427</c:v>
                </c:pt>
                <c:pt idx="49">
                  <c:v>23.428571428571427</c:v>
                </c:pt>
                <c:pt idx="50">
                  <c:v>24.5</c:v>
                </c:pt>
                <c:pt idx="51">
                  <c:v>24.5</c:v>
                </c:pt>
                <c:pt idx="52">
                  <c:v>25.678571428571427</c:v>
                </c:pt>
                <c:pt idx="53">
                  <c:v>25.678571428571427</c:v>
                </c:pt>
                <c:pt idx="54">
                  <c:v>26.214285714285715</c:v>
                </c:pt>
                <c:pt idx="55">
                  <c:v>26.214285714285715</c:v>
                </c:pt>
                <c:pt idx="56">
                  <c:v>27.071428571428573</c:v>
                </c:pt>
                <c:pt idx="57">
                  <c:v>27.071428571428573</c:v>
                </c:pt>
                <c:pt idx="58">
                  <c:v>29.107142857142858</c:v>
                </c:pt>
                <c:pt idx="59">
                  <c:v>29.107142857142858</c:v>
                </c:pt>
                <c:pt idx="60">
                  <c:v>29.642857142857142</c:v>
                </c:pt>
                <c:pt idx="61">
                  <c:v>29.642857142857142</c:v>
                </c:pt>
              </c:numCache>
            </c:numRef>
          </c:xVal>
          <c:yVal>
            <c:numRef>
              <c:f>Kaplan1!$H$7:$H$68</c:f>
              <c:numCache>
                <c:formatCode>0.000</c:formatCode>
                <c:ptCount val="62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96.666666666666671</c:v>
                </c:pt>
                <c:pt idx="5">
                  <c:v>96.666666666666671</c:v>
                </c:pt>
                <c:pt idx="6">
                  <c:v>96.666666666666671</c:v>
                </c:pt>
                <c:pt idx="7">
                  <c:v>96.666666666666671</c:v>
                </c:pt>
                <c:pt idx="8">
                  <c:v>96.666666666666671</c:v>
                </c:pt>
                <c:pt idx="9">
                  <c:v>96.666666666666671</c:v>
                </c:pt>
                <c:pt idx="10">
                  <c:v>96.666666666666671</c:v>
                </c:pt>
                <c:pt idx="11">
                  <c:v>96.666666666666671</c:v>
                </c:pt>
                <c:pt idx="12">
                  <c:v>96.666666666666671</c:v>
                </c:pt>
                <c:pt idx="13">
                  <c:v>96.666666666666671</c:v>
                </c:pt>
                <c:pt idx="14">
                  <c:v>96.666666666666671</c:v>
                </c:pt>
                <c:pt idx="15">
                  <c:v>96.666666666666671</c:v>
                </c:pt>
                <c:pt idx="16">
                  <c:v>92.638888888888886</c:v>
                </c:pt>
                <c:pt idx="17">
                  <c:v>92.638888888888886</c:v>
                </c:pt>
                <c:pt idx="18">
                  <c:v>92.638888888888886</c:v>
                </c:pt>
                <c:pt idx="19">
                  <c:v>92.638888888888886</c:v>
                </c:pt>
                <c:pt idx="20">
                  <c:v>92.638888888888886</c:v>
                </c:pt>
                <c:pt idx="21">
                  <c:v>92.638888888888886</c:v>
                </c:pt>
                <c:pt idx="22">
                  <c:v>92.638888888888886</c:v>
                </c:pt>
                <c:pt idx="23">
                  <c:v>92.638888888888886</c:v>
                </c:pt>
                <c:pt idx="24">
                  <c:v>92.638888888888886</c:v>
                </c:pt>
                <c:pt idx="25">
                  <c:v>92.638888888888886</c:v>
                </c:pt>
                <c:pt idx="26">
                  <c:v>92.638888888888886</c:v>
                </c:pt>
                <c:pt idx="27">
                  <c:v>92.638888888888886</c:v>
                </c:pt>
                <c:pt idx="28">
                  <c:v>87.492283950617292</c:v>
                </c:pt>
                <c:pt idx="29">
                  <c:v>87.492283950617292</c:v>
                </c:pt>
                <c:pt idx="30">
                  <c:v>87.492283950617292</c:v>
                </c:pt>
                <c:pt idx="31">
                  <c:v>87.492283950617292</c:v>
                </c:pt>
                <c:pt idx="32">
                  <c:v>87.492283950617292</c:v>
                </c:pt>
                <c:pt idx="33">
                  <c:v>87.492283950617292</c:v>
                </c:pt>
                <c:pt idx="34">
                  <c:v>87.492283950617292</c:v>
                </c:pt>
                <c:pt idx="35">
                  <c:v>87.492283950617292</c:v>
                </c:pt>
                <c:pt idx="36">
                  <c:v>87.492283950617292</c:v>
                </c:pt>
                <c:pt idx="37">
                  <c:v>87.492283950617292</c:v>
                </c:pt>
                <c:pt idx="38">
                  <c:v>87.492283950617292</c:v>
                </c:pt>
                <c:pt idx="39">
                  <c:v>87.492283950617292</c:v>
                </c:pt>
                <c:pt idx="40">
                  <c:v>87.492283950617292</c:v>
                </c:pt>
                <c:pt idx="41">
                  <c:v>87.492283950617292</c:v>
                </c:pt>
                <c:pt idx="42">
                  <c:v>87.492283950617292</c:v>
                </c:pt>
                <c:pt idx="43">
                  <c:v>87.492283950617292</c:v>
                </c:pt>
                <c:pt idx="44">
                  <c:v>87.492283950617292</c:v>
                </c:pt>
                <c:pt idx="45">
                  <c:v>87.492283950617292</c:v>
                </c:pt>
                <c:pt idx="46">
                  <c:v>87.492283950617292</c:v>
                </c:pt>
                <c:pt idx="47">
                  <c:v>87.492283950617292</c:v>
                </c:pt>
                <c:pt idx="48">
                  <c:v>87.492283950617292</c:v>
                </c:pt>
                <c:pt idx="49">
                  <c:v>87.492283950617292</c:v>
                </c:pt>
                <c:pt idx="50">
                  <c:v>87.492283950617292</c:v>
                </c:pt>
                <c:pt idx="51">
                  <c:v>87.492283950617292</c:v>
                </c:pt>
                <c:pt idx="52">
                  <c:v>87.492283950617292</c:v>
                </c:pt>
                <c:pt idx="53">
                  <c:v>87.492283950617292</c:v>
                </c:pt>
                <c:pt idx="54">
                  <c:v>87.492283950617292</c:v>
                </c:pt>
                <c:pt idx="55">
                  <c:v>87.492283950617292</c:v>
                </c:pt>
                <c:pt idx="56">
                  <c:v>87.492283950617292</c:v>
                </c:pt>
                <c:pt idx="57">
                  <c:v>87.492283950617292</c:v>
                </c:pt>
                <c:pt idx="58">
                  <c:v>87.492283950617292</c:v>
                </c:pt>
                <c:pt idx="59">
                  <c:v>87.492283950617292</c:v>
                </c:pt>
                <c:pt idx="60">
                  <c:v>87.492283950617292</c:v>
                </c:pt>
                <c:pt idx="61">
                  <c:v>87.49228395061729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3B-15D5-4EB8-B234-411324FFB9B4}"/>
            </c:ext>
          </c:extLst>
        </c:ser>
        <c:ser>
          <c:idx val="1"/>
          <c:order val="1"/>
          <c:tx>
            <c:v>再開</c:v>
          </c:tx>
          <c:spPr>
            <a:ln w="38100">
              <a:solidFill>
                <a:schemeClr val="accent2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3C-15D5-4EB8-B234-411324FFB9B4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3D-15D5-4EB8-B234-411324FFB9B4}"/>
              </c:ext>
            </c:extLst>
          </c:dPt>
          <c:dPt>
            <c:idx val="2"/>
            <c:bubble3D val="0"/>
            <c:extLst>
              <c:ext xmlns:c16="http://schemas.microsoft.com/office/drawing/2014/chart" uri="{C3380CC4-5D6E-409C-BE32-E72D297353CC}">
                <c16:uniqueId val="{0000003E-15D5-4EB8-B234-411324FFB9B4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3F-15D5-4EB8-B234-411324FFB9B4}"/>
              </c:ext>
            </c:extLst>
          </c:dPt>
          <c:dPt>
            <c:idx val="4"/>
            <c:bubble3D val="0"/>
            <c:extLst>
              <c:ext xmlns:c16="http://schemas.microsoft.com/office/drawing/2014/chart" uri="{C3380CC4-5D6E-409C-BE32-E72D297353CC}">
                <c16:uniqueId val="{00000040-15D5-4EB8-B234-411324FFB9B4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41-15D5-4EB8-B234-411324FFB9B4}"/>
              </c:ext>
            </c:extLst>
          </c:dPt>
          <c:dPt>
            <c:idx val="6"/>
            <c:bubble3D val="0"/>
            <c:extLst>
              <c:ext xmlns:c16="http://schemas.microsoft.com/office/drawing/2014/chart" uri="{C3380CC4-5D6E-409C-BE32-E72D297353CC}">
                <c16:uniqueId val="{00000042-15D5-4EB8-B234-411324FFB9B4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43-15D5-4EB8-B234-411324FFB9B4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44-15D5-4EB8-B234-411324FFB9B4}"/>
              </c:ext>
            </c:extLst>
          </c:dPt>
          <c:dPt>
            <c:idx val="10"/>
            <c:bubble3D val="0"/>
            <c:extLst>
              <c:ext xmlns:c16="http://schemas.microsoft.com/office/drawing/2014/chart" uri="{C3380CC4-5D6E-409C-BE32-E72D297353CC}">
                <c16:uniqueId val="{00000045-15D5-4EB8-B234-411324FFB9B4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46-15D5-4EB8-B234-411324FFB9B4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47-15D5-4EB8-B234-411324FFB9B4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48-15D5-4EB8-B234-411324FFB9B4}"/>
              </c:ext>
            </c:extLst>
          </c:dPt>
          <c:dPt>
            <c:idx val="14"/>
            <c:bubble3D val="0"/>
            <c:extLst>
              <c:ext xmlns:c16="http://schemas.microsoft.com/office/drawing/2014/chart" uri="{C3380CC4-5D6E-409C-BE32-E72D297353CC}">
                <c16:uniqueId val="{00000049-15D5-4EB8-B234-411324FFB9B4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4A-15D5-4EB8-B234-411324FFB9B4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4B-15D5-4EB8-B234-411324FFB9B4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4C-15D5-4EB8-B234-411324FFB9B4}"/>
              </c:ext>
            </c:extLst>
          </c:dPt>
          <c:dPt>
            <c:idx val="18"/>
            <c:bubble3D val="0"/>
            <c:extLst>
              <c:ext xmlns:c16="http://schemas.microsoft.com/office/drawing/2014/chart" uri="{C3380CC4-5D6E-409C-BE32-E72D297353CC}">
                <c16:uniqueId val="{0000004D-15D5-4EB8-B234-411324FFB9B4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4E-15D5-4EB8-B234-411324FFB9B4}"/>
              </c:ext>
            </c:extLst>
          </c:dPt>
          <c:dPt>
            <c:idx val="20"/>
            <c:bubble3D val="0"/>
            <c:extLst>
              <c:ext xmlns:c16="http://schemas.microsoft.com/office/drawing/2014/chart" uri="{C3380CC4-5D6E-409C-BE32-E72D297353CC}">
                <c16:uniqueId val="{0000004F-15D5-4EB8-B234-411324FFB9B4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50-15D5-4EB8-B234-411324FFB9B4}"/>
              </c:ext>
            </c:extLst>
          </c:dPt>
          <c:dPt>
            <c:idx val="22"/>
            <c:bubble3D val="0"/>
            <c:extLst>
              <c:ext xmlns:c16="http://schemas.microsoft.com/office/drawing/2014/chart" uri="{C3380CC4-5D6E-409C-BE32-E72D297353CC}">
                <c16:uniqueId val="{00000051-15D5-4EB8-B234-411324FFB9B4}"/>
              </c:ext>
            </c:extLst>
          </c:dPt>
          <c:dPt>
            <c:idx val="23"/>
            <c:bubble3D val="0"/>
            <c:extLst>
              <c:ext xmlns:c16="http://schemas.microsoft.com/office/drawing/2014/chart" uri="{C3380CC4-5D6E-409C-BE32-E72D297353CC}">
                <c16:uniqueId val="{00000052-15D5-4EB8-B234-411324FFB9B4}"/>
              </c:ext>
            </c:extLst>
          </c:dPt>
          <c:dPt>
            <c:idx val="24"/>
            <c:bubble3D val="0"/>
            <c:extLst>
              <c:ext xmlns:c16="http://schemas.microsoft.com/office/drawing/2014/chart" uri="{C3380CC4-5D6E-409C-BE32-E72D297353CC}">
                <c16:uniqueId val="{00000053-15D5-4EB8-B234-411324FFB9B4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54-15D5-4EB8-B234-411324FFB9B4}"/>
              </c:ext>
            </c:extLst>
          </c:dPt>
          <c:dPt>
            <c:idx val="26"/>
            <c:bubble3D val="0"/>
            <c:extLst>
              <c:ext xmlns:c16="http://schemas.microsoft.com/office/drawing/2014/chart" uri="{C3380CC4-5D6E-409C-BE32-E72D297353CC}">
                <c16:uniqueId val="{00000055-15D5-4EB8-B234-411324FFB9B4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2!$I$7:$I$33</c:f>
                <c:numCache>
                  <c:formatCode>General</c:formatCode>
                  <c:ptCount val="27"/>
                  <c:pt idx="0">
                    <c:v>0</c:v>
                  </c:pt>
                  <c:pt idx="1">
                    <c:v>3</c:v>
                  </c:pt>
                  <c:pt idx="2">
                    <c:v>0</c:v>
                  </c:pt>
                  <c:pt idx="3">
                    <c:v>3</c:v>
                  </c:pt>
                  <c:pt idx="4">
                    <c:v>0</c:v>
                  </c:pt>
                  <c:pt idx="5">
                    <c:v>3</c:v>
                  </c:pt>
                  <c:pt idx="6">
                    <c:v>0</c:v>
                  </c:pt>
                  <c:pt idx="7">
                    <c:v>3</c:v>
                  </c:pt>
                  <c:pt idx="8">
                    <c:v>0</c:v>
                  </c:pt>
                  <c:pt idx="9">
                    <c:v>3</c:v>
                  </c:pt>
                  <c:pt idx="10">
                    <c:v>0</c:v>
                  </c:pt>
                  <c:pt idx="11">
                    <c:v>3</c:v>
                  </c:pt>
                  <c:pt idx="12">
                    <c:v>0</c:v>
                  </c:pt>
                  <c:pt idx="13">
                    <c:v>3</c:v>
                  </c:pt>
                  <c:pt idx="14">
                    <c:v>0</c:v>
                  </c:pt>
                  <c:pt idx="15">
                    <c:v>3</c:v>
                  </c:pt>
                  <c:pt idx="16">
                    <c:v>0</c:v>
                  </c:pt>
                  <c:pt idx="17">
                    <c:v>3</c:v>
                  </c:pt>
                  <c:pt idx="18">
                    <c:v>0</c:v>
                  </c:pt>
                  <c:pt idx="19">
                    <c:v>3</c:v>
                  </c:pt>
                  <c:pt idx="20">
                    <c:v>0</c:v>
                  </c:pt>
                  <c:pt idx="21">
                    <c:v>3</c:v>
                  </c:pt>
                  <c:pt idx="22">
                    <c:v>0</c:v>
                  </c:pt>
                  <c:pt idx="23">
                    <c:v>3</c:v>
                  </c:pt>
                  <c:pt idx="24">
                    <c:v>0</c:v>
                  </c:pt>
                  <c:pt idx="25">
                    <c:v>3</c:v>
                  </c:pt>
                  <c:pt idx="26">
                    <c:v>0</c:v>
                  </c:pt>
                </c:numCache>
              </c:numRef>
            </c:plus>
          </c:errBars>
          <c:xVal>
            <c:numRef>
              <c:f>Kaplan2!$G$7:$G$33</c:f>
              <c:numCache>
                <c:formatCode>0.000</c:formatCode>
                <c:ptCount val="27"/>
                <c:pt idx="0">
                  <c:v>0</c:v>
                </c:pt>
                <c:pt idx="1">
                  <c:v>5.6071428571428568</c:v>
                </c:pt>
                <c:pt idx="2">
                  <c:v>5.6071428571428568</c:v>
                </c:pt>
                <c:pt idx="3">
                  <c:v>7.1071428571428568</c:v>
                </c:pt>
                <c:pt idx="4">
                  <c:v>7.1071428571428568</c:v>
                </c:pt>
                <c:pt idx="5">
                  <c:v>8.1785714285714288</c:v>
                </c:pt>
                <c:pt idx="6">
                  <c:v>8.1785714285714288</c:v>
                </c:pt>
                <c:pt idx="7">
                  <c:v>10.964285714285714</c:v>
                </c:pt>
                <c:pt idx="8">
                  <c:v>10.964285714285714</c:v>
                </c:pt>
                <c:pt idx="9">
                  <c:v>12.464285714285714</c:v>
                </c:pt>
                <c:pt idx="10">
                  <c:v>12.464285714285714</c:v>
                </c:pt>
                <c:pt idx="11">
                  <c:v>13.928571428571429</c:v>
                </c:pt>
                <c:pt idx="12">
                  <c:v>13.928571428571429</c:v>
                </c:pt>
                <c:pt idx="13">
                  <c:v>14.142857142857142</c:v>
                </c:pt>
                <c:pt idx="14">
                  <c:v>14.142857142857142</c:v>
                </c:pt>
                <c:pt idx="15">
                  <c:v>15.75</c:v>
                </c:pt>
                <c:pt idx="16">
                  <c:v>15.75</c:v>
                </c:pt>
                <c:pt idx="17">
                  <c:v>17.964285714285715</c:v>
                </c:pt>
                <c:pt idx="18">
                  <c:v>17.964285714285715</c:v>
                </c:pt>
                <c:pt idx="19">
                  <c:v>18.214285714285715</c:v>
                </c:pt>
                <c:pt idx="20">
                  <c:v>18.214285714285715</c:v>
                </c:pt>
                <c:pt idx="21">
                  <c:v>24.107142857142858</c:v>
                </c:pt>
                <c:pt idx="22">
                  <c:v>24.107142857142858</c:v>
                </c:pt>
                <c:pt idx="23">
                  <c:v>26.642857142857142</c:v>
                </c:pt>
                <c:pt idx="24">
                  <c:v>26.642857142857142</c:v>
                </c:pt>
                <c:pt idx="25">
                  <c:v>31.642857142857142</c:v>
                </c:pt>
                <c:pt idx="26">
                  <c:v>31.642857142857142</c:v>
                </c:pt>
              </c:numCache>
            </c:numRef>
          </c:xVal>
          <c:yVal>
            <c:numRef>
              <c:f>Kaplan2!$H$7:$H$33</c:f>
              <c:numCache>
                <c:formatCode>0.000</c:formatCode>
                <c:ptCount val="27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  <c:pt idx="8">
                  <c:v>90.909090909090907</c:v>
                </c:pt>
                <c:pt idx="9">
                  <c:v>90.909090909090907</c:v>
                </c:pt>
                <c:pt idx="10">
                  <c:v>90.909090909090907</c:v>
                </c:pt>
                <c:pt idx="11">
                  <c:v>90.909090909090907</c:v>
                </c:pt>
                <c:pt idx="12">
                  <c:v>90.909090909090907</c:v>
                </c:pt>
                <c:pt idx="13">
                  <c:v>90.909090909090907</c:v>
                </c:pt>
                <c:pt idx="14">
                  <c:v>90.909090909090907</c:v>
                </c:pt>
                <c:pt idx="15">
                  <c:v>90.909090909090907</c:v>
                </c:pt>
                <c:pt idx="16">
                  <c:v>90.909090909090907</c:v>
                </c:pt>
                <c:pt idx="17">
                  <c:v>90.909090909090907</c:v>
                </c:pt>
                <c:pt idx="18">
                  <c:v>90.909090909090907</c:v>
                </c:pt>
                <c:pt idx="19">
                  <c:v>90.909090909090907</c:v>
                </c:pt>
                <c:pt idx="20">
                  <c:v>90.909090909090907</c:v>
                </c:pt>
                <c:pt idx="21">
                  <c:v>90.909090909090907</c:v>
                </c:pt>
                <c:pt idx="22">
                  <c:v>90.909090909090907</c:v>
                </c:pt>
                <c:pt idx="23">
                  <c:v>90.909090909090907</c:v>
                </c:pt>
                <c:pt idx="24">
                  <c:v>90.909090909090907</c:v>
                </c:pt>
                <c:pt idx="25">
                  <c:v>90.909090909090907</c:v>
                </c:pt>
                <c:pt idx="26">
                  <c:v>90.90909090909090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56-15D5-4EB8-B234-411324FFB9B4}"/>
            </c:ext>
          </c:extLst>
        </c:ser>
        <c:ser>
          <c:idx val="2"/>
          <c:order val="2"/>
          <c:tx>
            <c:v>中止</c:v>
          </c:tx>
          <c:spPr>
            <a:ln w="38100">
              <a:solidFill>
                <a:schemeClr val="accent5"/>
              </a:solidFill>
              <a:prstDash val="solid"/>
            </a:ln>
          </c:spPr>
          <c:marker>
            <c:symbol val="none"/>
          </c:marker>
          <c:dPt>
            <c:idx val="0"/>
            <c:bubble3D val="0"/>
            <c:extLst>
              <c:ext xmlns:c16="http://schemas.microsoft.com/office/drawing/2014/chart" uri="{C3380CC4-5D6E-409C-BE32-E72D297353CC}">
                <c16:uniqueId val="{00000057-15D5-4EB8-B234-411324FFB9B4}"/>
              </c:ext>
            </c:extLst>
          </c:dPt>
          <c:dPt>
            <c:idx val="1"/>
            <c:bubble3D val="0"/>
            <c:extLst>
              <c:ext xmlns:c16="http://schemas.microsoft.com/office/drawing/2014/chart" uri="{C3380CC4-5D6E-409C-BE32-E72D297353CC}">
                <c16:uniqueId val="{00000058-15D5-4EB8-B234-411324FFB9B4}"/>
              </c:ext>
            </c:extLst>
          </c:dPt>
          <c:dPt>
            <c:idx val="3"/>
            <c:bubble3D val="0"/>
            <c:extLst>
              <c:ext xmlns:c16="http://schemas.microsoft.com/office/drawing/2014/chart" uri="{C3380CC4-5D6E-409C-BE32-E72D297353CC}">
                <c16:uniqueId val="{00000059-15D5-4EB8-B234-411324FFB9B4}"/>
              </c:ext>
            </c:extLst>
          </c:dPt>
          <c:dPt>
            <c:idx val="5"/>
            <c:bubble3D val="0"/>
            <c:extLst>
              <c:ext xmlns:c16="http://schemas.microsoft.com/office/drawing/2014/chart" uri="{C3380CC4-5D6E-409C-BE32-E72D297353CC}">
                <c16:uniqueId val="{0000005A-15D5-4EB8-B234-411324FFB9B4}"/>
              </c:ext>
            </c:extLst>
          </c:dPt>
          <c:dPt>
            <c:idx val="7"/>
            <c:bubble3D val="0"/>
            <c:extLst>
              <c:ext xmlns:c16="http://schemas.microsoft.com/office/drawing/2014/chart" uri="{C3380CC4-5D6E-409C-BE32-E72D297353CC}">
                <c16:uniqueId val="{0000005B-15D5-4EB8-B234-411324FFB9B4}"/>
              </c:ext>
            </c:extLst>
          </c:dPt>
          <c:dPt>
            <c:idx val="9"/>
            <c:bubble3D val="0"/>
            <c:extLst>
              <c:ext xmlns:c16="http://schemas.microsoft.com/office/drawing/2014/chart" uri="{C3380CC4-5D6E-409C-BE32-E72D297353CC}">
                <c16:uniqueId val="{0000005C-15D5-4EB8-B234-411324FFB9B4}"/>
              </c:ext>
            </c:extLst>
          </c:dPt>
          <c:dPt>
            <c:idx val="11"/>
            <c:bubble3D val="0"/>
            <c:extLst>
              <c:ext xmlns:c16="http://schemas.microsoft.com/office/drawing/2014/chart" uri="{C3380CC4-5D6E-409C-BE32-E72D297353CC}">
                <c16:uniqueId val="{0000005D-15D5-4EB8-B234-411324FFB9B4}"/>
              </c:ext>
            </c:extLst>
          </c:dPt>
          <c:dPt>
            <c:idx val="12"/>
            <c:bubble3D val="0"/>
            <c:extLst>
              <c:ext xmlns:c16="http://schemas.microsoft.com/office/drawing/2014/chart" uri="{C3380CC4-5D6E-409C-BE32-E72D297353CC}">
                <c16:uniqueId val="{0000005E-15D5-4EB8-B234-411324FFB9B4}"/>
              </c:ext>
            </c:extLst>
          </c:dPt>
          <c:dPt>
            <c:idx val="13"/>
            <c:bubble3D val="0"/>
            <c:extLst>
              <c:ext xmlns:c16="http://schemas.microsoft.com/office/drawing/2014/chart" uri="{C3380CC4-5D6E-409C-BE32-E72D297353CC}">
                <c16:uniqueId val="{0000005F-15D5-4EB8-B234-411324FFB9B4}"/>
              </c:ext>
            </c:extLst>
          </c:dPt>
          <c:dPt>
            <c:idx val="15"/>
            <c:bubble3D val="0"/>
            <c:extLst>
              <c:ext xmlns:c16="http://schemas.microsoft.com/office/drawing/2014/chart" uri="{C3380CC4-5D6E-409C-BE32-E72D297353CC}">
                <c16:uniqueId val="{00000060-15D5-4EB8-B234-411324FFB9B4}"/>
              </c:ext>
            </c:extLst>
          </c:dPt>
          <c:dPt>
            <c:idx val="16"/>
            <c:bubble3D val="0"/>
            <c:extLst>
              <c:ext xmlns:c16="http://schemas.microsoft.com/office/drawing/2014/chart" uri="{C3380CC4-5D6E-409C-BE32-E72D297353CC}">
                <c16:uniqueId val="{00000061-15D5-4EB8-B234-411324FFB9B4}"/>
              </c:ext>
            </c:extLst>
          </c:dPt>
          <c:dPt>
            <c:idx val="17"/>
            <c:bubble3D val="0"/>
            <c:extLst>
              <c:ext xmlns:c16="http://schemas.microsoft.com/office/drawing/2014/chart" uri="{C3380CC4-5D6E-409C-BE32-E72D297353CC}">
                <c16:uniqueId val="{00000062-15D5-4EB8-B234-411324FFB9B4}"/>
              </c:ext>
            </c:extLst>
          </c:dPt>
          <c:dPt>
            <c:idx val="19"/>
            <c:bubble3D val="0"/>
            <c:extLst>
              <c:ext xmlns:c16="http://schemas.microsoft.com/office/drawing/2014/chart" uri="{C3380CC4-5D6E-409C-BE32-E72D297353CC}">
                <c16:uniqueId val="{00000063-15D5-4EB8-B234-411324FFB9B4}"/>
              </c:ext>
            </c:extLst>
          </c:dPt>
          <c:dPt>
            <c:idx val="21"/>
            <c:bubble3D val="0"/>
            <c:extLst>
              <c:ext xmlns:c16="http://schemas.microsoft.com/office/drawing/2014/chart" uri="{C3380CC4-5D6E-409C-BE32-E72D297353CC}">
                <c16:uniqueId val="{00000064-15D5-4EB8-B234-411324FFB9B4}"/>
              </c:ext>
            </c:extLst>
          </c:dPt>
          <c:dPt>
            <c:idx val="23"/>
            <c:bubble3D val="0"/>
            <c:extLst>
              <c:ext xmlns:c16="http://schemas.microsoft.com/office/drawing/2014/chart" uri="{C3380CC4-5D6E-409C-BE32-E72D297353CC}">
                <c16:uniqueId val="{00000065-15D5-4EB8-B234-411324FFB9B4}"/>
              </c:ext>
            </c:extLst>
          </c:dPt>
          <c:dPt>
            <c:idx val="24"/>
            <c:bubble3D val="0"/>
            <c:extLst>
              <c:ext xmlns:c16="http://schemas.microsoft.com/office/drawing/2014/chart" uri="{C3380CC4-5D6E-409C-BE32-E72D297353CC}">
                <c16:uniqueId val="{00000066-15D5-4EB8-B234-411324FFB9B4}"/>
              </c:ext>
            </c:extLst>
          </c:dPt>
          <c:dPt>
            <c:idx val="25"/>
            <c:bubble3D val="0"/>
            <c:extLst>
              <c:ext xmlns:c16="http://schemas.microsoft.com/office/drawing/2014/chart" uri="{C3380CC4-5D6E-409C-BE32-E72D297353CC}">
                <c16:uniqueId val="{00000067-15D5-4EB8-B234-411324FFB9B4}"/>
              </c:ext>
            </c:extLst>
          </c:dPt>
          <c:dPt>
            <c:idx val="26"/>
            <c:bubble3D val="0"/>
            <c:extLst>
              <c:ext xmlns:c16="http://schemas.microsoft.com/office/drawing/2014/chart" uri="{C3380CC4-5D6E-409C-BE32-E72D297353CC}">
                <c16:uniqueId val="{00000068-15D5-4EB8-B234-411324FFB9B4}"/>
              </c:ext>
            </c:extLst>
          </c:dPt>
          <c:dPt>
            <c:idx val="27"/>
            <c:bubble3D val="0"/>
            <c:extLst>
              <c:ext xmlns:c16="http://schemas.microsoft.com/office/drawing/2014/chart" uri="{C3380CC4-5D6E-409C-BE32-E72D297353CC}">
                <c16:uniqueId val="{00000069-15D5-4EB8-B234-411324FFB9B4}"/>
              </c:ext>
            </c:extLst>
          </c:dPt>
          <c:dPt>
            <c:idx val="29"/>
            <c:bubble3D val="0"/>
            <c:extLst>
              <c:ext xmlns:c16="http://schemas.microsoft.com/office/drawing/2014/chart" uri="{C3380CC4-5D6E-409C-BE32-E72D297353CC}">
                <c16:uniqueId val="{0000006A-15D5-4EB8-B234-411324FFB9B4}"/>
              </c:ext>
            </c:extLst>
          </c:dPt>
          <c:dPt>
            <c:idx val="30"/>
            <c:bubble3D val="0"/>
            <c:extLst>
              <c:ext xmlns:c16="http://schemas.microsoft.com/office/drawing/2014/chart" uri="{C3380CC4-5D6E-409C-BE32-E72D297353CC}">
                <c16:uniqueId val="{0000006B-15D5-4EB8-B234-411324FFB9B4}"/>
              </c:ext>
            </c:extLst>
          </c:dPt>
          <c:dPt>
            <c:idx val="31"/>
            <c:bubble3D val="0"/>
            <c:extLst>
              <c:ext xmlns:c16="http://schemas.microsoft.com/office/drawing/2014/chart" uri="{C3380CC4-5D6E-409C-BE32-E72D297353CC}">
                <c16:uniqueId val="{0000006C-15D5-4EB8-B234-411324FFB9B4}"/>
              </c:ext>
            </c:extLst>
          </c:dPt>
          <c:dPt>
            <c:idx val="33"/>
            <c:bubble3D val="0"/>
            <c:extLst>
              <c:ext xmlns:c16="http://schemas.microsoft.com/office/drawing/2014/chart" uri="{C3380CC4-5D6E-409C-BE32-E72D297353CC}">
                <c16:uniqueId val="{0000006D-15D5-4EB8-B234-411324FFB9B4}"/>
              </c:ext>
            </c:extLst>
          </c:dPt>
          <c:dPt>
            <c:idx val="34"/>
            <c:bubble3D val="0"/>
            <c:extLst>
              <c:ext xmlns:c16="http://schemas.microsoft.com/office/drawing/2014/chart" uri="{C3380CC4-5D6E-409C-BE32-E72D297353CC}">
                <c16:uniqueId val="{0000006E-15D5-4EB8-B234-411324FFB9B4}"/>
              </c:ext>
            </c:extLst>
          </c:dPt>
          <c:dPt>
            <c:idx val="35"/>
            <c:bubble3D val="0"/>
            <c:extLst>
              <c:ext xmlns:c16="http://schemas.microsoft.com/office/drawing/2014/chart" uri="{C3380CC4-5D6E-409C-BE32-E72D297353CC}">
                <c16:uniqueId val="{0000006F-15D5-4EB8-B234-411324FFB9B4}"/>
              </c:ext>
            </c:extLst>
          </c:dPt>
          <c:dPt>
            <c:idx val="36"/>
            <c:bubble3D val="0"/>
            <c:extLst>
              <c:ext xmlns:c16="http://schemas.microsoft.com/office/drawing/2014/chart" uri="{C3380CC4-5D6E-409C-BE32-E72D297353CC}">
                <c16:uniqueId val="{00000070-15D5-4EB8-B234-411324FFB9B4}"/>
              </c:ext>
            </c:extLst>
          </c:dPt>
          <c:dPt>
            <c:idx val="37"/>
            <c:bubble3D val="0"/>
            <c:extLst>
              <c:ext xmlns:c16="http://schemas.microsoft.com/office/drawing/2014/chart" uri="{C3380CC4-5D6E-409C-BE32-E72D297353CC}">
                <c16:uniqueId val="{00000071-15D5-4EB8-B234-411324FFB9B4}"/>
              </c:ext>
            </c:extLst>
          </c:dPt>
          <c:dPt>
            <c:idx val="39"/>
            <c:bubble3D val="0"/>
            <c:extLst>
              <c:ext xmlns:c16="http://schemas.microsoft.com/office/drawing/2014/chart" uri="{C3380CC4-5D6E-409C-BE32-E72D297353CC}">
                <c16:uniqueId val="{00000072-15D5-4EB8-B234-411324FFB9B4}"/>
              </c:ext>
            </c:extLst>
          </c:dPt>
          <c:dPt>
            <c:idx val="40"/>
            <c:bubble3D val="0"/>
            <c:extLst>
              <c:ext xmlns:c16="http://schemas.microsoft.com/office/drawing/2014/chart" uri="{C3380CC4-5D6E-409C-BE32-E72D297353CC}">
                <c16:uniqueId val="{00000073-15D5-4EB8-B234-411324FFB9B4}"/>
              </c:ext>
            </c:extLst>
          </c:dPt>
          <c:dPt>
            <c:idx val="41"/>
            <c:bubble3D val="0"/>
            <c:extLst>
              <c:ext xmlns:c16="http://schemas.microsoft.com/office/drawing/2014/chart" uri="{C3380CC4-5D6E-409C-BE32-E72D297353CC}">
                <c16:uniqueId val="{00000074-15D5-4EB8-B234-411324FFB9B4}"/>
              </c:ext>
            </c:extLst>
          </c:dPt>
          <c:dPt>
            <c:idx val="42"/>
            <c:bubble3D val="0"/>
            <c:extLst>
              <c:ext xmlns:c16="http://schemas.microsoft.com/office/drawing/2014/chart" uri="{C3380CC4-5D6E-409C-BE32-E72D297353CC}">
                <c16:uniqueId val="{00000075-15D5-4EB8-B234-411324FFB9B4}"/>
              </c:ext>
            </c:extLst>
          </c:dPt>
          <c:dPt>
            <c:idx val="43"/>
            <c:bubble3D val="0"/>
            <c:extLst>
              <c:ext xmlns:c16="http://schemas.microsoft.com/office/drawing/2014/chart" uri="{C3380CC4-5D6E-409C-BE32-E72D297353CC}">
                <c16:uniqueId val="{00000076-15D5-4EB8-B234-411324FFB9B4}"/>
              </c:ext>
            </c:extLst>
          </c:dPt>
          <c:dPt>
            <c:idx val="45"/>
            <c:bubble3D val="0"/>
            <c:extLst>
              <c:ext xmlns:c16="http://schemas.microsoft.com/office/drawing/2014/chart" uri="{C3380CC4-5D6E-409C-BE32-E72D297353CC}">
                <c16:uniqueId val="{00000077-15D5-4EB8-B234-411324FFB9B4}"/>
              </c:ext>
            </c:extLst>
          </c:dPt>
          <c:dPt>
            <c:idx val="46"/>
            <c:bubble3D val="0"/>
            <c:extLst>
              <c:ext xmlns:c16="http://schemas.microsoft.com/office/drawing/2014/chart" uri="{C3380CC4-5D6E-409C-BE32-E72D297353CC}">
                <c16:uniqueId val="{00000078-15D5-4EB8-B234-411324FFB9B4}"/>
              </c:ext>
            </c:extLst>
          </c:dPt>
          <c:dPt>
            <c:idx val="47"/>
            <c:bubble3D val="0"/>
            <c:extLst>
              <c:ext xmlns:c16="http://schemas.microsoft.com/office/drawing/2014/chart" uri="{C3380CC4-5D6E-409C-BE32-E72D297353CC}">
                <c16:uniqueId val="{00000079-15D5-4EB8-B234-411324FFB9B4}"/>
              </c:ext>
            </c:extLst>
          </c:dPt>
          <c:dPt>
            <c:idx val="48"/>
            <c:bubble3D val="0"/>
            <c:extLst>
              <c:ext xmlns:c16="http://schemas.microsoft.com/office/drawing/2014/chart" uri="{C3380CC4-5D6E-409C-BE32-E72D297353CC}">
                <c16:uniqueId val="{0000007A-15D5-4EB8-B234-411324FFB9B4}"/>
              </c:ext>
            </c:extLst>
          </c:dPt>
          <c:dPt>
            <c:idx val="49"/>
            <c:bubble3D val="0"/>
            <c:extLst>
              <c:ext xmlns:c16="http://schemas.microsoft.com/office/drawing/2014/chart" uri="{C3380CC4-5D6E-409C-BE32-E72D297353CC}">
                <c16:uniqueId val="{0000007B-15D5-4EB8-B234-411324FFB9B4}"/>
              </c:ext>
            </c:extLst>
          </c:dPt>
          <c:dPt>
            <c:idx val="50"/>
            <c:bubble3D val="0"/>
            <c:extLst>
              <c:ext xmlns:c16="http://schemas.microsoft.com/office/drawing/2014/chart" uri="{C3380CC4-5D6E-409C-BE32-E72D297353CC}">
                <c16:uniqueId val="{0000007C-15D5-4EB8-B234-411324FFB9B4}"/>
              </c:ext>
            </c:extLst>
          </c:dPt>
          <c:dPt>
            <c:idx val="51"/>
            <c:bubble3D val="0"/>
            <c:extLst>
              <c:ext xmlns:c16="http://schemas.microsoft.com/office/drawing/2014/chart" uri="{C3380CC4-5D6E-409C-BE32-E72D297353CC}">
                <c16:uniqueId val="{0000007D-15D5-4EB8-B234-411324FFB9B4}"/>
              </c:ext>
            </c:extLst>
          </c:dPt>
          <c:dPt>
            <c:idx val="52"/>
            <c:bubble3D val="0"/>
            <c:extLst>
              <c:ext xmlns:c16="http://schemas.microsoft.com/office/drawing/2014/chart" uri="{C3380CC4-5D6E-409C-BE32-E72D297353CC}">
                <c16:uniqueId val="{0000007E-15D5-4EB8-B234-411324FFB9B4}"/>
              </c:ext>
            </c:extLst>
          </c:dPt>
          <c:dPt>
            <c:idx val="53"/>
            <c:bubble3D val="0"/>
            <c:extLst>
              <c:ext xmlns:c16="http://schemas.microsoft.com/office/drawing/2014/chart" uri="{C3380CC4-5D6E-409C-BE32-E72D297353CC}">
                <c16:uniqueId val="{0000007F-15D5-4EB8-B234-411324FFB9B4}"/>
              </c:ext>
            </c:extLst>
          </c:dPt>
          <c:dPt>
            <c:idx val="54"/>
            <c:bubble3D val="0"/>
            <c:extLst>
              <c:ext xmlns:c16="http://schemas.microsoft.com/office/drawing/2014/chart" uri="{C3380CC4-5D6E-409C-BE32-E72D297353CC}">
                <c16:uniqueId val="{00000080-15D5-4EB8-B234-411324FFB9B4}"/>
              </c:ext>
            </c:extLst>
          </c:dPt>
          <c:dPt>
            <c:idx val="55"/>
            <c:bubble3D val="0"/>
            <c:extLst>
              <c:ext xmlns:c16="http://schemas.microsoft.com/office/drawing/2014/chart" uri="{C3380CC4-5D6E-409C-BE32-E72D297353CC}">
                <c16:uniqueId val="{00000081-15D5-4EB8-B234-411324FFB9B4}"/>
              </c:ext>
            </c:extLst>
          </c:dPt>
          <c:dPt>
            <c:idx val="56"/>
            <c:bubble3D val="0"/>
            <c:extLst>
              <c:ext xmlns:c16="http://schemas.microsoft.com/office/drawing/2014/chart" uri="{C3380CC4-5D6E-409C-BE32-E72D297353CC}">
                <c16:uniqueId val="{00000082-15D5-4EB8-B234-411324FFB9B4}"/>
              </c:ext>
            </c:extLst>
          </c:dPt>
          <c:dPt>
            <c:idx val="57"/>
            <c:bubble3D val="0"/>
            <c:extLst>
              <c:ext xmlns:c16="http://schemas.microsoft.com/office/drawing/2014/chart" uri="{C3380CC4-5D6E-409C-BE32-E72D297353CC}">
                <c16:uniqueId val="{00000083-15D5-4EB8-B234-411324FFB9B4}"/>
              </c:ext>
            </c:extLst>
          </c:dPt>
          <c:dPt>
            <c:idx val="58"/>
            <c:bubble3D val="0"/>
            <c:extLst>
              <c:ext xmlns:c16="http://schemas.microsoft.com/office/drawing/2014/chart" uri="{C3380CC4-5D6E-409C-BE32-E72D297353CC}">
                <c16:uniqueId val="{00000084-15D5-4EB8-B234-411324FFB9B4}"/>
              </c:ext>
            </c:extLst>
          </c:dPt>
          <c:dPt>
            <c:idx val="60"/>
            <c:bubble3D val="0"/>
            <c:extLst>
              <c:ext xmlns:c16="http://schemas.microsoft.com/office/drawing/2014/chart" uri="{C3380CC4-5D6E-409C-BE32-E72D297353CC}">
                <c16:uniqueId val="{00000085-15D5-4EB8-B234-411324FFB9B4}"/>
              </c:ext>
            </c:extLst>
          </c:dPt>
          <c:dPt>
            <c:idx val="61"/>
            <c:bubble3D val="0"/>
            <c:extLst>
              <c:ext xmlns:c16="http://schemas.microsoft.com/office/drawing/2014/chart" uri="{C3380CC4-5D6E-409C-BE32-E72D297353CC}">
                <c16:uniqueId val="{00000086-15D5-4EB8-B234-411324FFB9B4}"/>
              </c:ext>
            </c:extLst>
          </c:dPt>
          <c:dPt>
            <c:idx val="62"/>
            <c:bubble3D val="0"/>
            <c:extLst>
              <c:ext xmlns:c16="http://schemas.microsoft.com/office/drawing/2014/chart" uri="{C3380CC4-5D6E-409C-BE32-E72D297353CC}">
                <c16:uniqueId val="{00000087-15D5-4EB8-B234-411324FFB9B4}"/>
              </c:ext>
            </c:extLst>
          </c:dPt>
          <c:dPt>
            <c:idx val="63"/>
            <c:bubble3D val="0"/>
            <c:extLst>
              <c:ext xmlns:c16="http://schemas.microsoft.com/office/drawing/2014/chart" uri="{C3380CC4-5D6E-409C-BE32-E72D297353CC}">
                <c16:uniqueId val="{00000088-15D5-4EB8-B234-411324FFB9B4}"/>
              </c:ext>
            </c:extLst>
          </c:dPt>
          <c:dPt>
            <c:idx val="64"/>
            <c:bubble3D val="0"/>
            <c:extLst>
              <c:ext xmlns:c16="http://schemas.microsoft.com/office/drawing/2014/chart" uri="{C3380CC4-5D6E-409C-BE32-E72D297353CC}">
                <c16:uniqueId val="{00000089-15D5-4EB8-B234-411324FFB9B4}"/>
              </c:ext>
            </c:extLst>
          </c:dPt>
          <c:dPt>
            <c:idx val="65"/>
            <c:bubble3D val="0"/>
            <c:extLst>
              <c:ext xmlns:c16="http://schemas.microsoft.com/office/drawing/2014/chart" uri="{C3380CC4-5D6E-409C-BE32-E72D297353CC}">
                <c16:uniqueId val="{0000008A-15D5-4EB8-B234-411324FFB9B4}"/>
              </c:ext>
            </c:extLst>
          </c:dPt>
          <c:dPt>
            <c:idx val="66"/>
            <c:bubble3D val="0"/>
            <c:extLst>
              <c:ext xmlns:c16="http://schemas.microsoft.com/office/drawing/2014/chart" uri="{C3380CC4-5D6E-409C-BE32-E72D297353CC}">
                <c16:uniqueId val="{0000008B-15D5-4EB8-B234-411324FFB9B4}"/>
              </c:ext>
            </c:extLst>
          </c:dPt>
          <c:dPt>
            <c:idx val="67"/>
            <c:bubble3D val="0"/>
            <c:extLst>
              <c:ext xmlns:c16="http://schemas.microsoft.com/office/drawing/2014/chart" uri="{C3380CC4-5D6E-409C-BE32-E72D297353CC}">
                <c16:uniqueId val="{0000008C-15D5-4EB8-B234-411324FFB9B4}"/>
              </c:ext>
            </c:extLst>
          </c:dPt>
          <c:dPt>
            <c:idx val="68"/>
            <c:bubble3D val="0"/>
            <c:extLst>
              <c:ext xmlns:c16="http://schemas.microsoft.com/office/drawing/2014/chart" uri="{C3380CC4-5D6E-409C-BE32-E72D297353CC}">
                <c16:uniqueId val="{0000008D-15D5-4EB8-B234-411324FFB9B4}"/>
              </c:ext>
            </c:extLst>
          </c:dPt>
          <c:dPt>
            <c:idx val="69"/>
            <c:bubble3D val="0"/>
            <c:extLst>
              <c:ext xmlns:c16="http://schemas.microsoft.com/office/drawing/2014/chart" uri="{C3380CC4-5D6E-409C-BE32-E72D297353CC}">
                <c16:uniqueId val="{0000008E-15D5-4EB8-B234-411324FFB9B4}"/>
              </c:ext>
            </c:extLst>
          </c:dPt>
          <c:dPt>
            <c:idx val="70"/>
            <c:bubble3D val="0"/>
            <c:extLst>
              <c:ext xmlns:c16="http://schemas.microsoft.com/office/drawing/2014/chart" uri="{C3380CC4-5D6E-409C-BE32-E72D297353CC}">
                <c16:uniqueId val="{0000008F-15D5-4EB8-B234-411324FFB9B4}"/>
              </c:ext>
            </c:extLst>
          </c:dPt>
          <c:dPt>
            <c:idx val="71"/>
            <c:bubble3D val="0"/>
            <c:extLst>
              <c:ext xmlns:c16="http://schemas.microsoft.com/office/drawing/2014/chart" uri="{C3380CC4-5D6E-409C-BE32-E72D297353CC}">
                <c16:uniqueId val="{00000090-15D5-4EB8-B234-411324FFB9B4}"/>
              </c:ext>
            </c:extLst>
          </c:dPt>
          <c:errBars>
            <c:errDir val="y"/>
            <c:errBarType val="plus"/>
            <c:errValType val="cust"/>
            <c:noEndCap val="1"/>
            <c:plus>
              <c:numRef>
                <c:f>Kaplan3!$I$7:$I$78</c:f>
                <c:numCache>
                  <c:formatCode>General</c:formatCode>
                  <c:ptCount val="72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  <c:pt idx="9">
                    <c:v>0</c:v>
                  </c:pt>
                  <c:pt idx="10">
                    <c:v>0</c:v>
                  </c:pt>
                  <c:pt idx="11">
                    <c:v>3</c:v>
                  </c:pt>
                  <c:pt idx="12">
                    <c:v>0</c:v>
                  </c:pt>
                  <c:pt idx="13">
                    <c:v>0</c:v>
                  </c:pt>
                  <c:pt idx="14">
                    <c:v>0</c:v>
                  </c:pt>
                  <c:pt idx="15">
                    <c:v>3</c:v>
                  </c:pt>
                  <c:pt idx="16">
                    <c:v>0</c:v>
                  </c:pt>
                  <c:pt idx="17">
                    <c:v>0</c:v>
                  </c:pt>
                  <c:pt idx="18">
                    <c:v>0</c:v>
                  </c:pt>
                  <c:pt idx="19">
                    <c:v>0</c:v>
                  </c:pt>
                  <c:pt idx="20">
                    <c:v>0</c:v>
                  </c:pt>
                  <c:pt idx="21">
                    <c:v>0</c:v>
                  </c:pt>
                  <c:pt idx="22">
                    <c:v>0</c:v>
                  </c:pt>
                  <c:pt idx="23">
                    <c:v>3</c:v>
                  </c:pt>
                  <c:pt idx="24">
                    <c:v>0</c:v>
                  </c:pt>
                  <c:pt idx="25">
                    <c:v>3</c:v>
                  </c:pt>
                  <c:pt idx="26">
                    <c:v>0</c:v>
                  </c:pt>
                  <c:pt idx="27">
                    <c:v>0</c:v>
                  </c:pt>
                  <c:pt idx="28">
                    <c:v>0</c:v>
                  </c:pt>
                  <c:pt idx="29">
                    <c:v>3</c:v>
                  </c:pt>
                  <c:pt idx="30">
                    <c:v>0</c:v>
                  </c:pt>
                  <c:pt idx="31">
                    <c:v>0</c:v>
                  </c:pt>
                  <c:pt idx="32">
                    <c:v>0</c:v>
                  </c:pt>
                  <c:pt idx="33">
                    <c:v>3</c:v>
                  </c:pt>
                  <c:pt idx="34">
                    <c:v>0</c:v>
                  </c:pt>
                  <c:pt idx="35">
                    <c:v>3</c:v>
                  </c:pt>
                  <c:pt idx="36">
                    <c:v>0</c:v>
                  </c:pt>
                  <c:pt idx="37">
                    <c:v>0</c:v>
                  </c:pt>
                  <c:pt idx="38">
                    <c:v>0</c:v>
                  </c:pt>
                  <c:pt idx="39">
                    <c:v>3</c:v>
                  </c:pt>
                  <c:pt idx="40">
                    <c:v>0</c:v>
                  </c:pt>
                  <c:pt idx="41">
                    <c:v>3</c:v>
                  </c:pt>
                  <c:pt idx="42">
                    <c:v>0</c:v>
                  </c:pt>
                  <c:pt idx="43">
                    <c:v>0</c:v>
                  </c:pt>
                  <c:pt idx="44">
                    <c:v>0</c:v>
                  </c:pt>
                  <c:pt idx="45">
                    <c:v>3</c:v>
                  </c:pt>
                  <c:pt idx="46">
                    <c:v>0</c:v>
                  </c:pt>
                  <c:pt idx="47">
                    <c:v>3</c:v>
                  </c:pt>
                  <c:pt idx="48">
                    <c:v>0</c:v>
                  </c:pt>
                  <c:pt idx="49">
                    <c:v>3</c:v>
                  </c:pt>
                  <c:pt idx="50">
                    <c:v>0</c:v>
                  </c:pt>
                  <c:pt idx="51">
                    <c:v>3</c:v>
                  </c:pt>
                  <c:pt idx="52">
                    <c:v>0</c:v>
                  </c:pt>
                  <c:pt idx="53">
                    <c:v>3</c:v>
                  </c:pt>
                  <c:pt idx="54">
                    <c:v>0</c:v>
                  </c:pt>
                  <c:pt idx="55">
                    <c:v>0</c:v>
                  </c:pt>
                  <c:pt idx="56">
                    <c:v>3</c:v>
                  </c:pt>
                  <c:pt idx="57">
                    <c:v>0</c:v>
                  </c:pt>
                  <c:pt idx="58">
                    <c:v>0</c:v>
                  </c:pt>
                  <c:pt idx="59">
                    <c:v>0</c:v>
                  </c:pt>
                  <c:pt idx="60">
                    <c:v>3</c:v>
                  </c:pt>
                  <c:pt idx="61">
                    <c:v>0</c:v>
                  </c:pt>
                  <c:pt idx="62">
                    <c:v>3</c:v>
                  </c:pt>
                  <c:pt idx="63">
                    <c:v>0</c:v>
                  </c:pt>
                  <c:pt idx="64">
                    <c:v>3</c:v>
                  </c:pt>
                  <c:pt idx="65">
                    <c:v>0</c:v>
                  </c:pt>
                  <c:pt idx="66">
                    <c:v>3</c:v>
                  </c:pt>
                  <c:pt idx="67">
                    <c:v>0</c:v>
                  </c:pt>
                  <c:pt idx="68">
                    <c:v>3</c:v>
                  </c:pt>
                  <c:pt idx="69">
                    <c:v>0</c:v>
                  </c:pt>
                  <c:pt idx="70">
                    <c:v>3</c:v>
                  </c:pt>
                  <c:pt idx="71">
                    <c:v>0</c:v>
                  </c:pt>
                </c:numCache>
              </c:numRef>
            </c:plus>
          </c:errBars>
          <c:xVal>
            <c:numRef>
              <c:f>Kaplan3!$G$7:$G$78</c:f>
              <c:numCache>
                <c:formatCode>0.000</c:formatCode>
                <c:ptCount val="72"/>
                <c:pt idx="0">
                  <c:v>0</c:v>
                </c:pt>
                <c:pt idx="1">
                  <c:v>1.9285714285714286</c:v>
                </c:pt>
                <c:pt idx="2">
                  <c:v>1.9285714285714286</c:v>
                </c:pt>
                <c:pt idx="3">
                  <c:v>2.25</c:v>
                </c:pt>
                <c:pt idx="4">
                  <c:v>2.25</c:v>
                </c:pt>
                <c:pt idx="5">
                  <c:v>2.3214285714285716</c:v>
                </c:pt>
                <c:pt idx="6">
                  <c:v>2.3214285714285716</c:v>
                </c:pt>
                <c:pt idx="7">
                  <c:v>2.4642857142857144</c:v>
                </c:pt>
                <c:pt idx="8">
                  <c:v>2.4642857142857144</c:v>
                </c:pt>
                <c:pt idx="9">
                  <c:v>3.0714285714285716</c:v>
                </c:pt>
                <c:pt idx="10">
                  <c:v>3.0714285714285716</c:v>
                </c:pt>
                <c:pt idx="11">
                  <c:v>3.3571428571428572</c:v>
                </c:pt>
                <c:pt idx="12">
                  <c:v>3.3571428571428572</c:v>
                </c:pt>
                <c:pt idx="13">
                  <c:v>3.5</c:v>
                </c:pt>
                <c:pt idx="14">
                  <c:v>3.5</c:v>
                </c:pt>
                <c:pt idx="15">
                  <c:v>4.25</c:v>
                </c:pt>
                <c:pt idx="16">
                  <c:v>4.25</c:v>
                </c:pt>
                <c:pt idx="17">
                  <c:v>4.3214285714285712</c:v>
                </c:pt>
                <c:pt idx="18">
                  <c:v>4.3214285714285712</c:v>
                </c:pt>
                <c:pt idx="19">
                  <c:v>5</c:v>
                </c:pt>
                <c:pt idx="20">
                  <c:v>5</c:v>
                </c:pt>
                <c:pt idx="21">
                  <c:v>5.4285714285714288</c:v>
                </c:pt>
                <c:pt idx="22">
                  <c:v>5.4285714285714288</c:v>
                </c:pt>
                <c:pt idx="23">
                  <c:v>7.1071428571428568</c:v>
                </c:pt>
                <c:pt idx="24">
                  <c:v>7.1071428571428568</c:v>
                </c:pt>
                <c:pt idx="25">
                  <c:v>7.3214285714285712</c:v>
                </c:pt>
                <c:pt idx="26">
                  <c:v>7.3214285714285712</c:v>
                </c:pt>
                <c:pt idx="27">
                  <c:v>8.1785714285714288</c:v>
                </c:pt>
                <c:pt idx="28">
                  <c:v>8.1785714285714288</c:v>
                </c:pt>
                <c:pt idx="29">
                  <c:v>8.3214285714285712</c:v>
                </c:pt>
                <c:pt idx="30">
                  <c:v>8.3214285714285712</c:v>
                </c:pt>
                <c:pt idx="31">
                  <c:v>8.3571428571428577</c:v>
                </c:pt>
                <c:pt idx="32">
                  <c:v>8.3571428571428577</c:v>
                </c:pt>
                <c:pt idx="33">
                  <c:v>9</c:v>
                </c:pt>
                <c:pt idx="34">
                  <c:v>9</c:v>
                </c:pt>
                <c:pt idx="35">
                  <c:v>9.5</c:v>
                </c:pt>
                <c:pt idx="36">
                  <c:v>9.5</c:v>
                </c:pt>
                <c:pt idx="37">
                  <c:v>10.607142857142858</c:v>
                </c:pt>
                <c:pt idx="38">
                  <c:v>10.607142857142858</c:v>
                </c:pt>
                <c:pt idx="39">
                  <c:v>11.964285714285714</c:v>
                </c:pt>
                <c:pt idx="40">
                  <c:v>11.964285714285714</c:v>
                </c:pt>
                <c:pt idx="41">
                  <c:v>12.392857142857142</c:v>
                </c:pt>
                <c:pt idx="42">
                  <c:v>12.392857142857142</c:v>
                </c:pt>
                <c:pt idx="43">
                  <c:v>13.214285714285714</c:v>
                </c:pt>
                <c:pt idx="44">
                  <c:v>13.214285714285714</c:v>
                </c:pt>
                <c:pt idx="45">
                  <c:v>13.785714285714286</c:v>
                </c:pt>
                <c:pt idx="46">
                  <c:v>13.785714285714286</c:v>
                </c:pt>
                <c:pt idx="47">
                  <c:v>14.285714285714286</c:v>
                </c:pt>
                <c:pt idx="48">
                  <c:v>14.285714285714286</c:v>
                </c:pt>
                <c:pt idx="49">
                  <c:v>17</c:v>
                </c:pt>
                <c:pt idx="50">
                  <c:v>17</c:v>
                </c:pt>
                <c:pt idx="51">
                  <c:v>20.25</c:v>
                </c:pt>
                <c:pt idx="52">
                  <c:v>20.25</c:v>
                </c:pt>
                <c:pt idx="53">
                  <c:v>21.571428571428573</c:v>
                </c:pt>
                <c:pt idx="54">
                  <c:v>21.571428571428573</c:v>
                </c:pt>
                <c:pt idx="55">
                  <c:v>21.607142857142858</c:v>
                </c:pt>
                <c:pt idx="56">
                  <c:v>22</c:v>
                </c:pt>
                <c:pt idx="57">
                  <c:v>22</c:v>
                </c:pt>
                <c:pt idx="58">
                  <c:v>22.428571428571427</c:v>
                </c:pt>
                <c:pt idx="59">
                  <c:v>22.428571428571427</c:v>
                </c:pt>
                <c:pt idx="60">
                  <c:v>24.75</c:v>
                </c:pt>
                <c:pt idx="61">
                  <c:v>24.75</c:v>
                </c:pt>
                <c:pt idx="62">
                  <c:v>25.607142857142858</c:v>
                </c:pt>
                <c:pt idx="63">
                  <c:v>25.607142857142858</c:v>
                </c:pt>
                <c:pt idx="64">
                  <c:v>26</c:v>
                </c:pt>
                <c:pt idx="65">
                  <c:v>26</c:v>
                </c:pt>
                <c:pt idx="66">
                  <c:v>26.428571428571427</c:v>
                </c:pt>
                <c:pt idx="67">
                  <c:v>26.428571428571427</c:v>
                </c:pt>
                <c:pt idx="68">
                  <c:v>27</c:v>
                </c:pt>
                <c:pt idx="69">
                  <c:v>27</c:v>
                </c:pt>
                <c:pt idx="70">
                  <c:v>27.5</c:v>
                </c:pt>
                <c:pt idx="71">
                  <c:v>27.5</c:v>
                </c:pt>
              </c:numCache>
            </c:numRef>
          </c:xVal>
          <c:yVal>
            <c:numRef>
              <c:f>Kaplan3!$H$7:$H$78</c:f>
              <c:numCache>
                <c:formatCode>0.000</c:formatCode>
                <c:ptCount val="72"/>
                <c:pt idx="0">
                  <c:v>100</c:v>
                </c:pt>
                <c:pt idx="1">
                  <c:v>100</c:v>
                </c:pt>
                <c:pt idx="2">
                  <c:v>97.222222222222214</c:v>
                </c:pt>
                <c:pt idx="3">
                  <c:v>97.222222222222214</c:v>
                </c:pt>
                <c:pt idx="4">
                  <c:v>94.444444444444443</c:v>
                </c:pt>
                <c:pt idx="5">
                  <c:v>94.444444444444443</c:v>
                </c:pt>
                <c:pt idx="6">
                  <c:v>91.666666666666657</c:v>
                </c:pt>
                <c:pt idx="7">
                  <c:v>91.666666666666657</c:v>
                </c:pt>
                <c:pt idx="8">
                  <c:v>88.888888888888886</c:v>
                </c:pt>
                <c:pt idx="9">
                  <c:v>88.888888888888886</c:v>
                </c:pt>
                <c:pt idx="10">
                  <c:v>86.1111111111111</c:v>
                </c:pt>
                <c:pt idx="11">
                  <c:v>86.1111111111111</c:v>
                </c:pt>
                <c:pt idx="12">
                  <c:v>86.1111111111111</c:v>
                </c:pt>
                <c:pt idx="13">
                  <c:v>86.1111111111111</c:v>
                </c:pt>
                <c:pt idx="14">
                  <c:v>83.240740740740733</c:v>
                </c:pt>
                <c:pt idx="15">
                  <c:v>83.240740740740733</c:v>
                </c:pt>
                <c:pt idx="16">
                  <c:v>83.240740740740733</c:v>
                </c:pt>
                <c:pt idx="17">
                  <c:v>83.240740740740733</c:v>
                </c:pt>
                <c:pt idx="18">
                  <c:v>80.267857142857153</c:v>
                </c:pt>
                <c:pt idx="19">
                  <c:v>80.267857142857153</c:v>
                </c:pt>
                <c:pt idx="20">
                  <c:v>77.294973544973544</c:v>
                </c:pt>
                <c:pt idx="21">
                  <c:v>77.294973544973544</c:v>
                </c:pt>
                <c:pt idx="22">
                  <c:v>74.32208994708995</c:v>
                </c:pt>
                <c:pt idx="23">
                  <c:v>74.32208994708995</c:v>
                </c:pt>
                <c:pt idx="24">
                  <c:v>74.32208994708995</c:v>
                </c:pt>
                <c:pt idx="25">
                  <c:v>74.32208994708995</c:v>
                </c:pt>
                <c:pt idx="26">
                  <c:v>74.32208994708995</c:v>
                </c:pt>
                <c:pt idx="27">
                  <c:v>74.32208994708995</c:v>
                </c:pt>
                <c:pt idx="28">
                  <c:v>71.090694731999079</c:v>
                </c:pt>
                <c:pt idx="29">
                  <c:v>71.090694731999079</c:v>
                </c:pt>
                <c:pt idx="30">
                  <c:v>71.090694731999079</c:v>
                </c:pt>
                <c:pt idx="31">
                  <c:v>71.090694731999079</c:v>
                </c:pt>
                <c:pt idx="32">
                  <c:v>67.705423554284835</c:v>
                </c:pt>
                <c:pt idx="33">
                  <c:v>67.705423554284835</c:v>
                </c:pt>
                <c:pt idx="34">
                  <c:v>67.705423554284835</c:v>
                </c:pt>
                <c:pt idx="35">
                  <c:v>67.705423554284835</c:v>
                </c:pt>
                <c:pt idx="36">
                  <c:v>67.705423554284835</c:v>
                </c:pt>
                <c:pt idx="37">
                  <c:v>67.705423554284835</c:v>
                </c:pt>
                <c:pt idx="38">
                  <c:v>63.944011134602341</c:v>
                </c:pt>
                <c:pt idx="39">
                  <c:v>63.944011134602341</c:v>
                </c:pt>
                <c:pt idx="40">
                  <c:v>63.944011134602341</c:v>
                </c:pt>
                <c:pt idx="41">
                  <c:v>63.944011134602341</c:v>
                </c:pt>
                <c:pt idx="42">
                  <c:v>63.944011134602341</c:v>
                </c:pt>
                <c:pt idx="43">
                  <c:v>63.944011134602341</c:v>
                </c:pt>
                <c:pt idx="44">
                  <c:v>59.681077058962181</c:v>
                </c:pt>
                <c:pt idx="45">
                  <c:v>59.681077058962181</c:v>
                </c:pt>
                <c:pt idx="46">
                  <c:v>59.681077058962181</c:v>
                </c:pt>
                <c:pt idx="47">
                  <c:v>59.681077058962181</c:v>
                </c:pt>
                <c:pt idx="48">
                  <c:v>59.681077058962181</c:v>
                </c:pt>
                <c:pt idx="49">
                  <c:v>59.681077058962181</c:v>
                </c:pt>
                <c:pt idx="50">
                  <c:v>59.681077058962181</c:v>
                </c:pt>
                <c:pt idx="51">
                  <c:v>59.681077058962181</c:v>
                </c:pt>
                <c:pt idx="52">
                  <c:v>59.681077058962181</c:v>
                </c:pt>
                <c:pt idx="53">
                  <c:v>59.681077058962181</c:v>
                </c:pt>
                <c:pt idx="54">
                  <c:v>59.681077058962181</c:v>
                </c:pt>
                <c:pt idx="55">
                  <c:v>59.681077058962181</c:v>
                </c:pt>
                <c:pt idx="56">
                  <c:v>59.681077058962181</c:v>
                </c:pt>
                <c:pt idx="57">
                  <c:v>59.681077058962181</c:v>
                </c:pt>
                <c:pt idx="58">
                  <c:v>59.681077058962181</c:v>
                </c:pt>
                <c:pt idx="59">
                  <c:v>51.155208907681867</c:v>
                </c:pt>
                <c:pt idx="60">
                  <c:v>51.155208907681867</c:v>
                </c:pt>
                <c:pt idx="61">
                  <c:v>51.155208907681867</c:v>
                </c:pt>
                <c:pt idx="62">
                  <c:v>51.155208907681867</c:v>
                </c:pt>
                <c:pt idx="63">
                  <c:v>51.155208907681867</c:v>
                </c:pt>
                <c:pt idx="64">
                  <c:v>51.155208907681867</c:v>
                </c:pt>
                <c:pt idx="65">
                  <c:v>51.155208907681867</c:v>
                </c:pt>
                <c:pt idx="66">
                  <c:v>51.155208907681867</c:v>
                </c:pt>
                <c:pt idx="67">
                  <c:v>51.155208907681867</c:v>
                </c:pt>
                <c:pt idx="68">
                  <c:v>51.155208907681867</c:v>
                </c:pt>
                <c:pt idx="69">
                  <c:v>51.155208907681867</c:v>
                </c:pt>
                <c:pt idx="70">
                  <c:v>51.155208907681867</c:v>
                </c:pt>
                <c:pt idx="71">
                  <c:v>51.1552089076818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91-15D5-4EB8-B234-411324FFB9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6028367"/>
        <c:axId val="2056029199"/>
      </c:scatterChart>
      <c:valAx>
        <c:axId val="2056028367"/>
        <c:scaling>
          <c:orientation val="minMax"/>
          <c:max val="35"/>
          <c:min val="0"/>
        </c:scaling>
        <c:delete val="0"/>
        <c:axPos val="b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2056029199"/>
        <c:crosses val="autoZero"/>
        <c:crossBetween val="midCat"/>
      </c:valAx>
      <c:valAx>
        <c:axId val="2056029199"/>
        <c:scaling>
          <c:orientation val="minMax"/>
          <c:max val="10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25400">
            <a:solidFill>
              <a:srgbClr val="000000"/>
            </a:solidFill>
            <a:prstDash val="solid"/>
          </a:ln>
        </c:spPr>
        <c:txPr>
          <a:bodyPr/>
          <a:lstStyle/>
          <a:p>
            <a:pPr>
              <a:defRPr sz="1200"/>
            </a:pPr>
            <a:endParaRPr lang="ja-JP"/>
          </a:p>
        </c:txPr>
        <c:crossAx val="2056028367"/>
        <c:crosses val="autoZero"/>
        <c:crossBetween val="midCat"/>
        <c:minorUnit val="20"/>
      </c:valAx>
      <c:spPr>
        <a:noFill/>
        <a:extLst>
          <a:ext uri="{909E8E84-426E-40DD-AFC4-6F175D3DCCD1}">
            <a14:hiddenFill xmlns:a14="http://schemas.microsoft.com/office/drawing/2010/main">
              <a:solidFill>
                <a:sysClr val="window" lastClr="FFFFFF"/>
              </a:solidFill>
            </a14:hiddenFill>
          </a:ext>
        </a:extLst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extLst>
      <a:ext uri="{909E8E84-426E-40DD-AFC4-6F175D3DCCD1}">
        <a14:hiddenFill xmlns:a14="http://schemas.microsoft.com/office/drawing/2010/main">
          <a:solidFill>
            <a:sysClr val="window" lastClr="FFFFFF"/>
          </a:solidFill>
        </a14:hiddenFill>
      </a:ext>
    </a:extLst>
  </c:spPr>
  <c:txPr>
    <a:bodyPr/>
    <a:lstStyle/>
    <a:p>
      <a:pPr>
        <a:defRPr sz="1200">
          <a:solidFill>
            <a:srgbClr val="000000"/>
          </a:solidFill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39949" y="883861"/>
            <a:ext cx="6119416" cy="1880235"/>
          </a:xfrm>
        </p:spPr>
        <p:txBody>
          <a:bodyPr anchor="b"/>
          <a:lstStyle>
            <a:lvl1pPr algn="ctr"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99914" y="2836605"/>
            <a:ext cx="5399485" cy="1303913"/>
          </a:xfrm>
        </p:spPr>
        <p:txBody>
          <a:bodyPr/>
          <a:lstStyle>
            <a:lvl1pPr marL="0" indent="0" algn="ctr">
              <a:buNone/>
              <a:defRPr sz="1890"/>
            </a:lvl1pPr>
            <a:lvl2pPr marL="359954" indent="0" algn="ctr">
              <a:buNone/>
              <a:defRPr sz="1575"/>
            </a:lvl2pPr>
            <a:lvl3pPr marL="719907" indent="0" algn="ctr">
              <a:buNone/>
              <a:defRPr sz="1417"/>
            </a:lvl3pPr>
            <a:lvl4pPr marL="1079861" indent="0" algn="ctr">
              <a:buNone/>
              <a:defRPr sz="1260"/>
            </a:lvl4pPr>
            <a:lvl5pPr marL="1439814" indent="0" algn="ctr">
              <a:buNone/>
              <a:defRPr sz="1260"/>
            </a:lvl5pPr>
            <a:lvl6pPr marL="1799768" indent="0" algn="ctr">
              <a:buNone/>
              <a:defRPr sz="1260"/>
            </a:lvl6pPr>
            <a:lvl7pPr marL="2159721" indent="0" algn="ctr">
              <a:buNone/>
              <a:defRPr sz="1260"/>
            </a:lvl7pPr>
            <a:lvl8pPr marL="2519675" indent="0" algn="ctr">
              <a:buNone/>
              <a:defRPr sz="1260"/>
            </a:lvl8pPr>
            <a:lvl9pPr marL="2879628" indent="0" algn="ctr">
              <a:buNone/>
              <a:defRPr sz="126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717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8802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52009" y="287536"/>
            <a:ext cx="1552352" cy="457682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4953" y="287536"/>
            <a:ext cx="4567064" cy="457682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7280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2384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1204" y="1346420"/>
            <a:ext cx="6209407" cy="2246530"/>
          </a:xfrm>
        </p:spPr>
        <p:txBody>
          <a:bodyPr anchor="b"/>
          <a:lstStyle>
            <a:lvl1pPr>
              <a:defRPr sz="472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1204" y="3614203"/>
            <a:ext cx="6209407" cy="118139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/>
                </a:solidFill>
              </a:defRPr>
            </a:lvl1pPr>
            <a:lvl2pPr marL="35995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19907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3pPr>
            <a:lvl4pPr marL="107986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39814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79976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59721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1967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79628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859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4953" y="1437680"/>
            <a:ext cx="3059708" cy="34266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44652" y="1437680"/>
            <a:ext cx="3059708" cy="34266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189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1" y="287537"/>
            <a:ext cx="6209407" cy="104388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891" y="1323916"/>
            <a:ext cx="3045646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891" y="1972747"/>
            <a:ext cx="3045646" cy="290161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44652" y="1323916"/>
            <a:ext cx="3060646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59954" indent="0">
              <a:buNone/>
              <a:defRPr sz="1575" b="1"/>
            </a:lvl2pPr>
            <a:lvl3pPr marL="719907" indent="0">
              <a:buNone/>
              <a:defRPr sz="1417" b="1"/>
            </a:lvl3pPr>
            <a:lvl4pPr marL="1079861" indent="0">
              <a:buNone/>
              <a:defRPr sz="1260" b="1"/>
            </a:lvl4pPr>
            <a:lvl5pPr marL="1439814" indent="0">
              <a:buNone/>
              <a:defRPr sz="1260" b="1"/>
            </a:lvl5pPr>
            <a:lvl6pPr marL="1799768" indent="0">
              <a:buNone/>
              <a:defRPr sz="1260" b="1"/>
            </a:lvl6pPr>
            <a:lvl7pPr marL="2159721" indent="0">
              <a:buNone/>
              <a:defRPr sz="1260" b="1"/>
            </a:lvl7pPr>
            <a:lvl8pPr marL="2519675" indent="0">
              <a:buNone/>
              <a:defRPr sz="1260" b="1"/>
            </a:lvl8pPr>
            <a:lvl9pPr marL="2879628" indent="0">
              <a:buNone/>
              <a:defRPr sz="126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44652" y="1972747"/>
            <a:ext cx="3060646" cy="290161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3943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1434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05275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360045"/>
            <a:ext cx="2321966" cy="1260158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60646" y="777598"/>
            <a:ext cx="3644652" cy="3837980"/>
          </a:xfrm>
        </p:spPr>
        <p:txBody>
          <a:bodyPr/>
          <a:lstStyle>
            <a:lvl1pPr>
              <a:defRPr sz="2519"/>
            </a:lvl1pPr>
            <a:lvl2pPr>
              <a:defRPr sz="2204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620202"/>
            <a:ext cx="2321966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9128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890" y="360045"/>
            <a:ext cx="2321966" cy="1260158"/>
          </a:xfrm>
        </p:spPr>
        <p:txBody>
          <a:bodyPr anchor="b"/>
          <a:lstStyle>
            <a:lvl1pPr>
              <a:defRPr sz="251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60646" y="777598"/>
            <a:ext cx="3644652" cy="3837980"/>
          </a:xfrm>
        </p:spPr>
        <p:txBody>
          <a:bodyPr anchor="t"/>
          <a:lstStyle>
            <a:lvl1pPr marL="0" indent="0">
              <a:buNone/>
              <a:defRPr sz="2519"/>
            </a:lvl1pPr>
            <a:lvl2pPr marL="359954" indent="0">
              <a:buNone/>
              <a:defRPr sz="2204"/>
            </a:lvl2pPr>
            <a:lvl3pPr marL="719907" indent="0">
              <a:buNone/>
              <a:defRPr sz="1890"/>
            </a:lvl3pPr>
            <a:lvl4pPr marL="1079861" indent="0">
              <a:buNone/>
              <a:defRPr sz="1575"/>
            </a:lvl4pPr>
            <a:lvl5pPr marL="1439814" indent="0">
              <a:buNone/>
              <a:defRPr sz="1575"/>
            </a:lvl5pPr>
            <a:lvl6pPr marL="1799768" indent="0">
              <a:buNone/>
              <a:defRPr sz="1575"/>
            </a:lvl6pPr>
            <a:lvl7pPr marL="2159721" indent="0">
              <a:buNone/>
              <a:defRPr sz="1575"/>
            </a:lvl7pPr>
            <a:lvl8pPr marL="2519675" indent="0">
              <a:buNone/>
              <a:defRPr sz="1575"/>
            </a:lvl8pPr>
            <a:lvl9pPr marL="2879628" indent="0">
              <a:buNone/>
              <a:defRPr sz="1575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890" y="1620202"/>
            <a:ext cx="2321966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59954" indent="0">
              <a:buNone/>
              <a:defRPr sz="1102"/>
            </a:lvl2pPr>
            <a:lvl3pPr marL="719907" indent="0">
              <a:buNone/>
              <a:defRPr sz="945"/>
            </a:lvl3pPr>
            <a:lvl4pPr marL="1079861" indent="0">
              <a:buNone/>
              <a:defRPr sz="787"/>
            </a:lvl4pPr>
            <a:lvl5pPr marL="1439814" indent="0">
              <a:buNone/>
              <a:defRPr sz="787"/>
            </a:lvl5pPr>
            <a:lvl6pPr marL="1799768" indent="0">
              <a:buNone/>
              <a:defRPr sz="787"/>
            </a:lvl6pPr>
            <a:lvl7pPr marL="2159721" indent="0">
              <a:buNone/>
              <a:defRPr sz="787"/>
            </a:lvl7pPr>
            <a:lvl8pPr marL="2519675" indent="0">
              <a:buNone/>
              <a:defRPr sz="787"/>
            </a:lvl8pPr>
            <a:lvl9pPr marL="2879628" indent="0">
              <a:buNone/>
              <a:defRPr sz="78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1324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4953" y="287537"/>
            <a:ext cx="6209407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53" y="1437680"/>
            <a:ext cx="6209407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4953" y="5005627"/>
            <a:ext cx="1619845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271B3-54A9-4451-9327-81DAA444A899}" type="datetimeFigureOut">
              <a:rPr kumimoji="1" lang="ja-JP" altLang="en-US" smtClean="0"/>
              <a:t>2021/8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84773" y="5005627"/>
            <a:ext cx="242976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084515" y="5005627"/>
            <a:ext cx="1619845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7A798C-9ECA-4935-8E58-0B31F25353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9126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19907" rtl="0" eaLnBrk="1" latinLnBrk="0" hangingPunct="1">
        <a:lnSpc>
          <a:spcPct val="90000"/>
        </a:lnSpc>
        <a:spcBef>
          <a:spcPct val="0"/>
        </a:spcBef>
        <a:buNone/>
        <a:defRPr kumimoji="1" sz="34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9977" indent="-179977" algn="l" defTabSz="71990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204" kern="1200">
          <a:solidFill>
            <a:schemeClr val="tx1"/>
          </a:solidFill>
          <a:latin typeface="+mn-lt"/>
          <a:ea typeface="+mn-ea"/>
          <a:cs typeface="+mn-cs"/>
        </a:defRPr>
      </a:lvl1pPr>
      <a:lvl2pPr marL="539930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899884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59837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619791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97974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339698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699652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3059605" indent="-179977" algn="l" defTabSz="719907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1pPr>
      <a:lvl2pPr marL="35995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719907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07986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4pPr>
      <a:lvl5pPr marL="1439814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5pPr>
      <a:lvl6pPr marL="179976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6pPr>
      <a:lvl7pPr marL="2159721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7pPr>
      <a:lvl8pPr marL="2519675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8pPr>
      <a:lvl9pPr marL="2879628" algn="l" defTabSz="719907" rtl="0" eaLnBrk="1" latinLnBrk="0" hangingPunct="1"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2" name="グラフ 41">
            <a:extLst>
              <a:ext uri="{FF2B5EF4-FFF2-40B4-BE49-F238E27FC236}">
                <a16:creationId xmlns:a16="http://schemas.microsoft.com/office/drawing/2014/main" id="{8EA0B5EA-23CA-4FAC-ADF7-62BC17A7575D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507943633"/>
              </p:ext>
            </p:extLst>
          </p:nvPr>
        </p:nvGraphicFramePr>
        <p:xfrm>
          <a:off x="1486428" y="-21366"/>
          <a:ext cx="5546905" cy="36238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D211C5E8-B412-44A9-A4F0-F33242D1599E}"/>
              </a:ext>
            </a:extLst>
          </p:cNvPr>
          <p:cNvSpPr txBox="1"/>
          <p:nvPr/>
        </p:nvSpPr>
        <p:spPr>
          <a:xfrm>
            <a:off x="4207396" y="3500057"/>
            <a:ext cx="10392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Time (month)</a:t>
            </a:r>
            <a:endParaRPr kumimoji="1" lang="ja-JP" altLang="en-US" sz="1200" dirty="0"/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B2DCE32E-1D1D-4EA9-9FA3-9EF93AAE70B6}"/>
              </a:ext>
            </a:extLst>
          </p:cNvPr>
          <p:cNvSpPr txBox="1"/>
          <p:nvPr/>
        </p:nvSpPr>
        <p:spPr>
          <a:xfrm>
            <a:off x="1745077" y="394084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1</a:t>
            </a:r>
            <a:endParaRPr kumimoji="1" lang="ja-JP" altLang="en-US" sz="1200" dirty="0"/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F8CC6286-56E6-460B-81E9-4341F6EFD847}"/>
              </a:ext>
            </a:extLst>
          </p:cNvPr>
          <p:cNvSpPr txBox="1"/>
          <p:nvPr/>
        </p:nvSpPr>
        <p:spPr>
          <a:xfrm>
            <a:off x="1744733" y="369657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4</a:t>
            </a:r>
            <a:endParaRPr kumimoji="1" lang="ja-JP" altLang="en-US" sz="1200" dirty="0"/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DFC29438-7775-44AD-9FFC-E6EED2AEFE78}"/>
              </a:ext>
            </a:extLst>
          </p:cNvPr>
          <p:cNvSpPr txBox="1"/>
          <p:nvPr/>
        </p:nvSpPr>
        <p:spPr>
          <a:xfrm>
            <a:off x="2481724" y="394084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1</a:t>
            </a:r>
            <a:endParaRPr kumimoji="1" lang="ja-JP" altLang="en-US" sz="1200" dirty="0"/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4121DD79-7C0E-4179-BCD5-9B2D10D11453}"/>
              </a:ext>
            </a:extLst>
          </p:cNvPr>
          <p:cNvSpPr txBox="1"/>
          <p:nvPr/>
        </p:nvSpPr>
        <p:spPr>
          <a:xfrm>
            <a:off x="2481724" y="369657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4</a:t>
            </a:r>
            <a:endParaRPr kumimoji="1" lang="ja-JP" altLang="en-US" sz="1200" dirty="0"/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2BABB285-24E7-4BA3-A2C5-BCF2172F0527}"/>
              </a:ext>
            </a:extLst>
          </p:cNvPr>
          <p:cNvSpPr txBox="1"/>
          <p:nvPr/>
        </p:nvSpPr>
        <p:spPr>
          <a:xfrm>
            <a:off x="3171651" y="3940844"/>
            <a:ext cx="367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24</a:t>
            </a:r>
            <a:endParaRPr kumimoji="1" lang="ja-JP" altLang="en-US" sz="1200" dirty="0"/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55869DFA-B67F-402C-B5FC-940BC4322366}"/>
              </a:ext>
            </a:extLst>
          </p:cNvPr>
          <p:cNvSpPr txBox="1"/>
          <p:nvPr/>
        </p:nvSpPr>
        <p:spPr>
          <a:xfrm>
            <a:off x="3171651" y="3696573"/>
            <a:ext cx="367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11</a:t>
            </a:r>
            <a:endParaRPr kumimoji="1" lang="ja-JP" altLang="en-US" sz="1200" dirty="0"/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F45D1759-436C-4D6E-9147-B964DF8E7D67}"/>
              </a:ext>
            </a:extLst>
          </p:cNvPr>
          <p:cNvSpPr txBox="1"/>
          <p:nvPr/>
        </p:nvSpPr>
        <p:spPr>
          <a:xfrm>
            <a:off x="3873294" y="394084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4</a:t>
            </a:r>
            <a:endParaRPr kumimoji="1" lang="ja-JP" altLang="en-US" sz="1200" dirty="0"/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6C7E508B-140B-48AF-BB15-10B8DC43DD37}"/>
              </a:ext>
            </a:extLst>
          </p:cNvPr>
          <p:cNvSpPr txBox="1"/>
          <p:nvPr/>
        </p:nvSpPr>
        <p:spPr>
          <a:xfrm>
            <a:off x="3915889" y="369657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6</a:t>
            </a:r>
            <a:endParaRPr kumimoji="1" lang="ja-JP" altLang="en-US" sz="1200" dirty="0"/>
          </a:p>
        </p:txBody>
      </p: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id="{29861061-9AE4-4C74-A73A-4EE942B3D37F}"/>
              </a:ext>
            </a:extLst>
          </p:cNvPr>
          <p:cNvSpPr txBox="1"/>
          <p:nvPr/>
        </p:nvSpPr>
        <p:spPr>
          <a:xfrm>
            <a:off x="4605479" y="3940844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9</a:t>
            </a:r>
            <a:endParaRPr kumimoji="1" lang="ja-JP" altLang="en-US" sz="1200" dirty="0"/>
          </a:p>
        </p:txBody>
      </p:sp>
      <p:sp>
        <p:nvSpPr>
          <p:cNvPr id="168" name="テキスト ボックス 167">
            <a:extLst>
              <a:ext uri="{FF2B5EF4-FFF2-40B4-BE49-F238E27FC236}">
                <a16:creationId xmlns:a16="http://schemas.microsoft.com/office/drawing/2014/main" id="{1A84CC83-5DA6-48F3-A2A7-39E8FCF87229}"/>
              </a:ext>
            </a:extLst>
          </p:cNvPr>
          <p:cNvSpPr txBox="1"/>
          <p:nvPr/>
        </p:nvSpPr>
        <p:spPr>
          <a:xfrm>
            <a:off x="4597058" y="369657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</a:t>
            </a:r>
            <a:endParaRPr kumimoji="1" lang="ja-JP" altLang="en-US" sz="1200" dirty="0"/>
          </a:p>
        </p:txBody>
      </p:sp>
      <p:sp>
        <p:nvSpPr>
          <p:cNvPr id="170" name="テキスト ボックス 169">
            <a:extLst>
              <a:ext uri="{FF2B5EF4-FFF2-40B4-BE49-F238E27FC236}">
                <a16:creationId xmlns:a16="http://schemas.microsoft.com/office/drawing/2014/main" id="{AB2797B4-88DC-4537-B9C0-531B263D5059}"/>
              </a:ext>
            </a:extLst>
          </p:cNvPr>
          <p:cNvSpPr txBox="1"/>
          <p:nvPr/>
        </p:nvSpPr>
        <p:spPr>
          <a:xfrm>
            <a:off x="5312730" y="3940844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</a:t>
            </a:r>
            <a:endParaRPr kumimoji="1" lang="ja-JP" altLang="en-US" sz="1200" dirty="0"/>
          </a:p>
        </p:txBody>
      </p:sp>
      <p:sp>
        <p:nvSpPr>
          <p:cNvPr id="172" name="テキスト ボックス 171">
            <a:extLst>
              <a:ext uri="{FF2B5EF4-FFF2-40B4-BE49-F238E27FC236}">
                <a16:creationId xmlns:a16="http://schemas.microsoft.com/office/drawing/2014/main" id="{BAF923C9-5D37-459E-BA0C-194A60964211}"/>
              </a:ext>
            </a:extLst>
          </p:cNvPr>
          <p:cNvSpPr txBox="1"/>
          <p:nvPr/>
        </p:nvSpPr>
        <p:spPr>
          <a:xfrm>
            <a:off x="5308104" y="369657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</a:t>
            </a:r>
            <a:endParaRPr kumimoji="1" lang="ja-JP" altLang="en-US" sz="1200" dirty="0"/>
          </a:p>
        </p:txBody>
      </p:sp>
      <p:sp>
        <p:nvSpPr>
          <p:cNvPr id="174" name="テキスト ボックス 173">
            <a:extLst>
              <a:ext uri="{FF2B5EF4-FFF2-40B4-BE49-F238E27FC236}">
                <a16:creationId xmlns:a16="http://schemas.microsoft.com/office/drawing/2014/main" id="{71953143-7837-42EC-B07D-DA5539E99B53}"/>
              </a:ext>
            </a:extLst>
          </p:cNvPr>
          <p:cNvSpPr txBox="1"/>
          <p:nvPr/>
        </p:nvSpPr>
        <p:spPr>
          <a:xfrm>
            <a:off x="6041671" y="3940844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</a:t>
            </a:r>
            <a:endParaRPr kumimoji="1" lang="ja-JP" altLang="en-US" sz="1200" dirty="0"/>
          </a:p>
        </p:txBody>
      </p: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C30B962C-E610-4097-AC4D-9E7709B77464}"/>
              </a:ext>
            </a:extLst>
          </p:cNvPr>
          <p:cNvSpPr txBox="1"/>
          <p:nvPr/>
        </p:nvSpPr>
        <p:spPr>
          <a:xfrm>
            <a:off x="6041671" y="369657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</a:t>
            </a:r>
            <a:endParaRPr kumimoji="1" lang="ja-JP" altLang="en-US" sz="1200" dirty="0"/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628B0AD0-9982-44A6-B031-7EC27A00C6AD}"/>
              </a:ext>
            </a:extLst>
          </p:cNvPr>
          <p:cNvSpPr txBox="1"/>
          <p:nvPr/>
        </p:nvSpPr>
        <p:spPr>
          <a:xfrm>
            <a:off x="821634" y="3438035"/>
            <a:ext cx="8180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No. at risk</a:t>
            </a:r>
            <a:endParaRPr kumimoji="1" lang="ja-JP" altLang="en-US" sz="1200" dirty="0"/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0069E8C7-C6A2-47BB-863E-B5290B541664}"/>
              </a:ext>
            </a:extLst>
          </p:cNvPr>
          <p:cNvSpPr txBox="1"/>
          <p:nvPr/>
        </p:nvSpPr>
        <p:spPr>
          <a:xfrm>
            <a:off x="6740527" y="3696573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</a:t>
            </a:r>
            <a:endParaRPr kumimoji="1" lang="ja-JP" altLang="en-US" sz="1200" dirty="0"/>
          </a:p>
        </p:txBody>
      </p:sp>
      <p:sp>
        <p:nvSpPr>
          <p:cNvPr id="182" name="テキスト ボックス 181">
            <a:extLst>
              <a:ext uri="{FF2B5EF4-FFF2-40B4-BE49-F238E27FC236}">
                <a16:creationId xmlns:a16="http://schemas.microsoft.com/office/drawing/2014/main" id="{B84FE761-7571-4753-8D0B-B709D7F03772}"/>
              </a:ext>
            </a:extLst>
          </p:cNvPr>
          <p:cNvSpPr txBox="1"/>
          <p:nvPr/>
        </p:nvSpPr>
        <p:spPr>
          <a:xfrm>
            <a:off x="6741067" y="3940844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</a:t>
            </a:r>
            <a:endParaRPr kumimoji="1" lang="ja-JP" altLang="en-US" sz="1200" dirty="0"/>
          </a:p>
        </p:txBody>
      </p:sp>
      <p:cxnSp>
        <p:nvCxnSpPr>
          <p:cNvPr id="194" name="直線コネクタ 193">
            <a:extLst>
              <a:ext uri="{FF2B5EF4-FFF2-40B4-BE49-F238E27FC236}">
                <a16:creationId xmlns:a16="http://schemas.microsoft.com/office/drawing/2014/main" id="{F83F25F2-1FAA-4A5F-B409-43FFCE5B3E00}"/>
              </a:ext>
            </a:extLst>
          </p:cNvPr>
          <p:cNvCxnSpPr>
            <a:cxnSpLocks/>
          </p:cNvCxnSpPr>
          <p:nvPr/>
        </p:nvCxnSpPr>
        <p:spPr>
          <a:xfrm>
            <a:off x="3469764" y="2120556"/>
            <a:ext cx="161926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線コネクタ 194">
            <a:extLst>
              <a:ext uri="{FF2B5EF4-FFF2-40B4-BE49-F238E27FC236}">
                <a16:creationId xmlns:a16="http://schemas.microsoft.com/office/drawing/2014/main" id="{201FFF33-D081-44B8-A155-E1CF1A98F553}"/>
              </a:ext>
            </a:extLst>
          </p:cNvPr>
          <p:cNvCxnSpPr>
            <a:cxnSpLocks/>
          </p:cNvCxnSpPr>
          <p:nvPr/>
        </p:nvCxnSpPr>
        <p:spPr>
          <a:xfrm>
            <a:off x="3469763" y="1923541"/>
            <a:ext cx="161924" cy="0"/>
          </a:xfrm>
          <a:prstGeom prst="line">
            <a:avLst/>
          </a:prstGeom>
          <a:ln w="38100">
            <a:solidFill>
              <a:schemeClr val="accent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テキスト ボックス 196">
            <a:extLst>
              <a:ext uri="{FF2B5EF4-FFF2-40B4-BE49-F238E27FC236}">
                <a16:creationId xmlns:a16="http://schemas.microsoft.com/office/drawing/2014/main" id="{98056808-983E-45C2-BC73-CAA14417FC88}"/>
              </a:ext>
            </a:extLst>
          </p:cNvPr>
          <p:cNvSpPr txBox="1"/>
          <p:nvPr/>
        </p:nvSpPr>
        <p:spPr>
          <a:xfrm>
            <a:off x="2462628" y="2496797"/>
            <a:ext cx="40379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239713">
              <a:tabLst>
                <a:tab pos="719138" algn="l"/>
              </a:tabLst>
            </a:pPr>
            <a:r>
              <a:rPr lang="en-US" altLang="ja-JP" sz="1200" dirty="0">
                <a:solidFill>
                  <a:prstClr val="black"/>
                </a:solidFill>
                <a:ea typeface="游ゴシック" panose="020B0400000000000000" pitchFamily="50" charset="-128"/>
              </a:rPr>
              <a:t>Log-rank	Readministration vs Continuation p=0.83</a:t>
            </a:r>
          </a:p>
          <a:p>
            <a:pPr defTabSz="239713">
              <a:tabLst>
                <a:tab pos="719138" algn="l"/>
              </a:tabLst>
            </a:pPr>
            <a:r>
              <a:rPr lang="en-US" altLang="ja-JP" sz="1200" dirty="0">
                <a:solidFill>
                  <a:prstClr val="black"/>
                </a:solidFill>
                <a:ea typeface="游ゴシック" panose="020B0400000000000000" pitchFamily="50" charset="-128"/>
              </a:rPr>
              <a:t>                    	Continuation vs No readministration p&lt;0.01</a:t>
            </a:r>
          </a:p>
          <a:p>
            <a:pPr defTabSz="239713">
              <a:tabLst>
                <a:tab pos="719138" algn="l"/>
              </a:tabLst>
            </a:pPr>
            <a:r>
              <a:rPr lang="en-US" altLang="ja-JP" sz="1200" dirty="0">
                <a:solidFill>
                  <a:prstClr val="black"/>
                </a:solidFill>
                <a:ea typeface="游ゴシック" panose="020B0400000000000000" pitchFamily="50" charset="-128"/>
              </a:rPr>
              <a:t>                  	Readministration vs No readministration p=0.031</a:t>
            </a:r>
            <a:endParaRPr lang="ja-JP" altLang="en-US" sz="1200" dirty="0">
              <a:solidFill>
                <a:prstClr val="black"/>
              </a:solidFill>
              <a:ea typeface="游ゴシック" panose="020B0400000000000000" pitchFamily="50" charset="-128"/>
            </a:endParaRPr>
          </a:p>
        </p:txBody>
      </p:sp>
      <p:sp>
        <p:nvSpPr>
          <p:cNvPr id="199" name="テキスト ボックス 198">
            <a:extLst>
              <a:ext uri="{FF2B5EF4-FFF2-40B4-BE49-F238E27FC236}">
                <a16:creationId xmlns:a16="http://schemas.microsoft.com/office/drawing/2014/main" id="{8229E77F-B649-4A79-876D-767F590BCD9C}"/>
              </a:ext>
            </a:extLst>
          </p:cNvPr>
          <p:cNvSpPr txBox="1"/>
          <p:nvPr/>
        </p:nvSpPr>
        <p:spPr>
          <a:xfrm rot="16200000">
            <a:off x="337094" y="1509215"/>
            <a:ext cx="19431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Overall survival (%)</a:t>
            </a:r>
            <a:endParaRPr kumimoji="1" lang="ja-JP" altLang="en-US" sz="1400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11516493-97E9-4BAF-8E84-76ECF8050606}"/>
              </a:ext>
            </a:extLst>
          </p:cNvPr>
          <p:cNvSpPr txBox="1"/>
          <p:nvPr/>
        </p:nvSpPr>
        <p:spPr>
          <a:xfrm>
            <a:off x="202103" y="3940844"/>
            <a:ext cx="15578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/>
              <a:t>Continuation</a:t>
            </a:r>
            <a:endParaRPr lang="ja-JP" altLang="en-US" sz="1200" dirty="0"/>
          </a:p>
        </p:txBody>
      </p:sp>
      <p:sp>
        <p:nvSpPr>
          <p:cNvPr id="68" name="テキスト ボックス 1">
            <a:extLst>
              <a:ext uri="{FF2B5EF4-FFF2-40B4-BE49-F238E27FC236}">
                <a16:creationId xmlns:a16="http://schemas.microsoft.com/office/drawing/2014/main" id="{E52B28A1-A923-445E-B5D4-3C3E0A2F4D1E}"/>
              </a:ext>
            </a:extLst>
          </p:cNvPr>
          <p:cNvSpPr txBox="1"/>
          <p:nvPr/>
        </p:nvSpPr>
        <p:spPr>
          <a:xfrm>
            <a:off x="24144" y="3696573"/>
            <a:ext cx="1735595" cy="31886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1200" dirty="0" err="1"/>
              <a:t>Readministration</a:t>
            </a:r>
            <a:endParaRPr lang="ja-JP" altLang="en-US" sz="1200" dirty="0"/>
          </a:p>
        </p:txBody>
      </p:sp>
      <p:sp>
        <p:nvSpPr>
          <p:cNvPr id="70" name="テキスト ボックス 1">
            <a:extLst>
              <a:ext uri="{FF2B5EF4-FFF2-40B4-BE49-F238E27FC236}">
                <a16:creationId xmlns:a16="http://schemas.microsoft.com/office/drawing/2014/main" id="{8279C8C8-BE71-4977-8A7A-DE520183F41A}"/>
              </a:ext>
            </a:extLst>
          </p:cNvPr>
          <p:cNvSpPr txBox="1"/>
          <p:nvPr/>
        </p:nvSpPr>
        <p:spPr>
          <a:xfrm>
            <a:off x="3684338" y="1749915"/>
            <a:ext cx="3059452" cy="347255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200" dirty="0" err="1"/>
              <a:t>Readministration</a:t>
            </a:r>
            <a:r>
              <a:rPr lang="en-US" altLang="ja-JP" sz="1200" dirty="0"/>
              <a:t> of anti-PD-1 (n=14)</a:t>
            </a:r>
            <a:endParaRPr lang="ja-JP" altLang="en-US" sz="1200" dirty="0"/>
          </a:p>
        </p:txBody>
      </p:sp>
      <p:sp>
        <p:nvSpPr>
          <p:cNvPr id="72" name="テキスト ボックス 1">
            <a:extLst>
              <a:ext uri="{FF2B5EF4-FFF2-40B4-BE49-F238E27FC236}">
                <a16:creationId xmlns:a16="http://schemas.microsoft.com/office/drawing/2014/main" id="{29AC60A8-5230-4D83-9525-2993AA7369C8}"/>
              </a:ext>
            </a:extLst>
          </p:cNvPr>
          <p:cNvSpPr txBox="1"/>
          <p:nvPr/>
        </p:nvSpPr>
        <p:spPr>
          <a:xfrm>
            <a:off x="3687449" y="1963073"/>
            <a:ext cx="2908804" cy="287203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200" dirty="0"/>
              <a:t>Continuation of anti-PD-1 (n=31)</a:t>
            </a:r>
            <a:endParaRPr lang="ja-JP" altLang="en-US" sz="1200" dirty="0"/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06897BA1-F74F-439C-A31D-EDD30C1DFED4}"/>
              </a:ext>
            </a:extLst>
          </p:cNvPr>
          <p:cNvCxnSpPr>
            <a:cxnSpLocks/>
          </p:cNvCxnSpPr>
          <p:nvPr/>
        </p:nvCxnSpPr>
        <p:spPr>
          <a:xfrm>
            <a:off x="3470361" y="2338007"/>
            <a:ext cx="161926" cy="0"/>
          </a:xfrm>
          <a:prstGeom prst="line">
            <a:avLst/>
          </a:prstGeom>
          <a:ln w="3810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1">
            <a:extLst>
              <a:ext uri="{FF2B5EF4-FFF2-40B4-BE49-F238E27FC236}">
                <a16:creationId xmlns:a16="http://schemas.microsoft.com/office/drawing/2014/main" id="{A3AF4D88-E400-4C19-B94D-82E140AF90C4}"/>
              </a:ext>
            </a:extLst>
          </p:cNvPr>
          <p:cNvSpPr txBox="1"/>
          <p:nvPr/>
        </p:nvSpPr>
        <p:spPr>
          <a:xfrm>
            <a:off x="3684339" y="2176910"/>
            <a:ext cx="3205175" cy="287203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altLang="ja-JP" sz="1200" dirty="0"/>
              <a:t>No readministration</a:t>
            </a:r>
            <a:r>
              <a:rPr lang="ja-JP" altLang="en-US" sz="1200" dirty="0"/>
              <a:t> </a:t>
            </a:r>
            <a:r>
              <a:rPr lang="en-US" altLang="ja-JP" sz="1200" dirty="0"/>
              <a:t>of anti-PD-1 (n=36)</a:t>
            </a:r>
            <a:endParaRPr lang="ja-JP" altLang="en-US" sz="1200" dirty="0"/>
          </a:p>
        </p:txBody>
      </p:sp>
      <p:sp>
        <p:nvSpPr>
          <p:cNvPr id="32" name="テキスト ボックス 1">
            <a:extLst>
              <a:ext uri="{FF2B5EF4-FFF2-40B4-BE49-F238E27FC236}">
                <a16:creationId xmlns:a16="http://schemas.microsoft.com/office/drawing/2014/main" id="{00991F26-2F59-43B3-8EE5-E257BDA222B2}"/>
              </a:ext>
            </a:extLst>
          </p:cNvPr>
          <p:cNvSpPr txBox="1"/>
          <p:nvPr/>
        </p:nvSpPr>
        <p:spPr>
          <a:xfrm>
            <a:off x="-60449" y="4164180"/>
            <a:ext cx="1820188" cy="272051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altLang="ja-JP" sz="1200" dirty="0"/>
              <a:t>No readministration</a:t>
            </a:r>
            <a:endParaRPr lang="ja-JP" altLang="en-US" sz="1200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FBE97C3-46EE-4DE3-AE33-61FF125F5CAA}"/>
              </a:ext>
            </a:extLst>
          </p:cNvPr>
          <p:cNvSpPr txBox="1"/>
          <p:nvPr/>
        </p:nvSpPr>
        <p:spPr>
          <a:xfrm>
            <a:off x="1740067" y="416170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36</a:t>
            </a:r>
            <a:endParaRPr kumimoji="1" lang="ja-JP" altLang="en-US" sz="12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3687B74-3E33-4097-BE09-E5E5B5B0A9C0}"/>
              </a:ext>
            </a:extLst>
          </p:cNvPr>
          <p:cNvSpPr txBox="1"/>
          <p:nvPr/>
        </p:nvSpPr>
        <p:spPr>
          <a:xfrm>
            <a:off x="2473754" y="416170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7</a:t>
            </a:r>
            <a:endParaRPr kumimoji="1" lang="ja-JP" altLang="en-US" sz="12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E1FA7B8-6962-4F7D-8767-C716DFB3878E}"/>
              </a:ext>
            </a:extLst>
          </p:cNvPr>
          <p:cNvSpPr txBox="1"/>
          <p:nvPr/>
        </p:nvSpPr>
        <p:spPr>
          <a:xfrm>
            <a:off x="3171651" y="4161706"/>
            <a:ext cx="3674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18</a:t>
            </a:r>
            <a:endParaRPr kumimoji="1" lang="ja-JP" altLang="en-US" sz="1200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F9E805E-0E09-4E2E-9093-C10A8F61EC65}"/>
              </a:ext>
            </a:extLst>
          </p:cNvPr>
          <p:cNvSpPr txBox="1"/>
          <p:nvPr/>
        </p:nvSpPr>
        <p:spPr>
          <a:xfrm>
            <a:off x="3870205" y="416170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2</a:t>
            </a:r>
            <a:endParaRPr kumimoji="1" lang="ja-JP" altLang="en-US" sz="12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91BB1DA-1D99-40AA-B42C-06F8F8574B13}"/>
              </a:ext>
            </a:extLst>
          </p:cNvPr>
          <p:cNvSpPr txBox="1"/>
          <p:nvPr/>
        </p:nvSpPr>
        <p:spPr>
          <a:xfrm>
            <a:off x="4581582" y="416170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1</a:t>
            </a:r>
            <a:endParaRPr kumimoji="1" lang="ja-JP" altLang="en-US" sz="1200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568EF79-ED3A-4AC8-9218-E565FDCCD51D}"/>
              </a:ext>
            </a:extLst>
          </p:cNvPr>
          <p:cNvSpPr txBox="1"/>
          <p:nvPr/>
        </p:nvSpPr>
        <p:spPr>
          <a:xfrm>
            <a:off x="5308104" y="416170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</a:t>
            </a:r>
            <a:endParaRPr kumimoji="1" lang="ja-JP" altLang="en-US" sz="1200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C2EFD59-F1E9-431B-B9B2-3DB39DAF9EE8}"/>
              </a:ext>
            </a:extLst>
          </p:cNvPr>
          <p:cNvSpPr txBox="1"/>
          <p:nvPr/>
        </p:nvSpPr>
        <p:spPr>
          <a:xfrm>
            <a:off x="6040119" y="416170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</a:t>
            </a:r>
            <a:endParaRPr kumimoji="1" lang="ja-JP" altLang="en-US" sz="1200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C96A51E-12E9-410C-9076-D51DB7FB1E44}"/>
              </a:ext>
            </a:extLst>
          </p:cNvPr>
          <p:cNvSpPr txBox="1"/>
          <p:nvPr/>
        </p:nvSpPr>
        <p:spPr>
          <a:xfrm>
            <a:off x="6741079" y="4161706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0</a:t>
            </a:r>
            <a:endParaRPr kumimoji="1" lang="ja-JP" altLang="en-US" sz="1200" dirty="0"/>
          </a:p>
        </p:txBody>
      </p:sp>
      <p:sp>
        <p:nvSpPr>
          <p:cNvPr id="41" name="テキスト ボックス 105">
            <a:extLst>
              <a:ext uri="{FF2B5EF4-FFF2-40B4-BE49-F238E27FC236}">
                <a16:creationId xmlns:a16="http://schemas.microsoft.com/office/drawing/2014/main" id="{CA030166-5B51-4B78-8F78-A23BC4330BA7}"/>
              </a:ext>
            </a:extLst>
          </p:cNvPr>
          <p:cNvSpPr txBox="1"/>
          <p:nvPr/>
        </p:nvSpPr>
        <p:spPr>
          <a:xfrm>
            <a:off x="5812" y="4449120"/>
            <a:ext cx="719350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18390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436782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2155172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873562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591952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4310345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5028734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747124" algn="l" defTabSz="1436782" rtl="0" eaLnBrk="1" latinLnBrk="0" hangingPunct="1"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400" b="1" dirty="0">
                <a:cs typeface="Times New Roman" pitchFamily="18" charset="0"/>
              </a:rPr>
              <a:t>Supplementary Figure S1. </a:t>
            </a:r>
            <a:r>
              <a:rPr lang="en-US" altLang="ja-JP" sz="1400" dirty="0">
                <a:cs typeface="Times New Roman" pitchFamily="18" charset="0"/>
              </a:rPr>
              <a:t>Kaplan-Meier curves for the 6-week landmark analysis of the overall survival of patients continuing anti-PD-1 treatment after irAE occurrence and those with or without the readministration of anti-PD-1 treatment after treatment discontinuation due to irAEs. PD-1, programmed-cell death-1; irAE, immune-related adverse event.</a:t>
            </a:r>
            <a:endParaRPr lang="ja-JP" altLang="en-US" sz="1400" dirty="0"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84861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9</TotalTime>
  <Words>141</Words>
  <Application>Microsoft Office PowerPoint</Application>
  <PresentationFormat>ユーザー設定</PresentationFormat>
  <Paragraphs>3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shiyafujisaki</dc:creator>
  <cp:lastModifiedBy>Watanabe Satoshi</cp:lastModifiedBy>
  <cp:revision>26</cp:revision>
  <dcterms:created xsi:type="dcterms:W3CDTF">2020-11-02T01:31:24Z</dcterms:created>
  <dcterms:modified xsi:type="dcterms:W3CDTF">2021-08-29T02:27:47Z</dcterms:modified>
</cp:coreProperties>
</file>